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3"/>
  </p:sldMasterIdLst>
  <p:sldIdLst>
    <p:sldId id="263" r:id="rId4"/>
    <p:sldId id="267" r:id="rId5"/>
    <p:sldId id="259" r:id="rId6"/>
    <p:sldId id="265" r:id="rId7"/>
    <p:sldId id="266" r:id="rId8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EEC2B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–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F5AB1C69-6EDB-4FF4-983F-18BD219EF322}" styleName="Medium Style 2 – Accent 3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3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3"/>
          </a:solidFill>
        </a:fill>
      </a:tcStyle>
    </a:firstRow>
  </a:tblStyle>
  <a:tblStyle styleId="{21E4AEA4-8DFA-4A89-87EB-49C32662AFE0}" styleName="Medium Style 2 – Accent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2">
              <a:tint val="20000"/>
            </a:schemeClr>
          </a:solidFill>
        </a:fill>
      </a:tcStyle>
    </a:wholeTbl>
    <a:band1H>
      <a:tcStyle>
        <a:tcBdr/>
        <a:fill>
          <a:solidFill>
            <a:schemeClr val="accent2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2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2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2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8669"/>
    <p:restoredTop sz="94669"/>
  </p:normalViewPr>
  <p:slideViewPr>
    <p:cSldViewPr snapToGrid="0">
      <p:cViewPr>
        <p:scale>
          <a:sx n="115" d="100"/>
          <a:sy n="115" d="100"/>
        </p:scale>
        <p:origin x="2304" y="-50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5.xml"/><Relationship Id="rId3" Type="http://schemas.openxmlformats.org/officeDocument/2006/relationships/slideMaster" Target="slideMasters/slideMaster1.xml"/><Relationship Id="rId7" Type="http://schemas.openxmlformats.org/officeDocument/2006/relationships/slide" Target="slides/slide4.xml"/><Relationship Id="rId12" Type="http://schemas.openxmlformats.org/officeDocument/2006/relationships/tableStyles" Target="tableStyle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slide" Target="slides/slide3.xml"/><Relationship Id="rId11" Type="http://schemas.openxmlformats.org/officeDocument/2006/relationships/theme" Target="theme/theme1.xml"/><Relationship Id="rId5" Type="http://schemas.openxmlformats.org/officeDocument/2006/relationships/slide" Target="slides/slide2.xml"/><Relationship Id="rId10" Type="http://schemas.openxmlformats.org/officeDocument/2006/relationships/viewProps" Target="viewProps.xml"/><Relationship Id="rId4" Type="http://schemas.openxmlformats.org/officeDocument/2006/relationships/slide" Target="slides/slide1.xml"/><Relationship Id="rId9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GB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81FF74-F85E-1B4D-835B-EF1AA8C13B22}" type="datetimeFigureOut">
              <a:rPr lang="en-CH" smtClean="0"/>
              <a:t>05.03.24</a:t>
            </a:fld>
            <a:endParaRPr lang="en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4EE2B1-B16D-1A43-A8B7-6D893387D606}" type="slidenum">
              <a:rPr lang="en-CH" smtClean="0"/>
              <a:t>‹#›</a:t>
            </a:fld>
            <a:endParaRPr lang="en-CH"/>
          </a:p>
        </p:txBody>
      </p:sp>
    </p:spTree>
    <p:extLst>
      <p:ext uri="{BB962C8B-B14F-4D97-AF65-F5344CB8AC3E}">
        <p14:creationId xmlns:p14="http://schemas.microsoft.com/office/powerpoint/2010/main" val="349985295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81FF74-F85E-1B4D-835B-EF1AA8C13B22}" type="datetimeFigureOut">
              <a:rPr lang="en-CH" smtClean="0"/>
              <a:t>05.03.24</a:t>
            </a:fld>
            <a:endParaRPr lang="en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4EE2B1-B16D-1A43-A8B7-6D893387D606}" type="slidenum">
              <a:rPr lang="en-CH" smtClean="0"/>
              <a:t>‹#›</a:t>
            </a:fld>
            <a:endParaRPr lang="en-CH"/>
          </a:p>
        </p:txBody>
      </p:sp>
    </p:spTree>
    <p:extLst>
      <p:ext uri="{BB962C8B-B14F-4D97-AF65-F5344CB8AC3E}">
        <p14:creationId xmlns:p14="http://schemas.microsoft.com/office/powerpoint/2010/main" val="384128689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81FF74-F85E-1B4D-835B-EF1AA8C13B22}" type="datetimeFigureOut">
              <a:rPr lang="en-CH" smtClean="0"/>
              <a:t>05.03.24</a:t>
            </a:fld>
            <a:endParaRPr lang="en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4EE2B1-B16D-1A43-A8B7-6D893387D606}" type="slidenum">
              <a:rPr lang="en-CH" smtClean="0"/>
              <a:t>‹#›</a:t>
            </a:fld>
            <a:endParaRPr lang="en-CH"/>
          </a:p>
        </p:txBody>
      </p:sp>
    </p:spTree>
    <p:extLst>
      <p:ext uri="{BB962C8B-B14F-4D97-AF65-F5344CB8AC3E}">
        <p14:creationId xmlns:p14="http://schemas.microsoft.com/office/powerpoint/2010/main" val="209113045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81FF74-F85E-1B4D-835B-EF1AA8C13B22}" type="datetimeFigureOut">
              <a:rPr lang="en-CH" smtClean="0"/>
              <a:t>05.03.24</a:t>
            </a:fld>
            <a:endParaRPr lang="en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4EE2B1-B16D-1A43-A8B7-6D893387D606}" type="slidenum">
              <a:rPr lang="en-CH" smtClean="0"/>
              <a:t>‹#›</a:t>
            </a:fld>
            <a:endParaRPr lang="en-CH"/>
          </a:p>
        </p:txBody>
      </p:sp>
    </p:spTree>
    <p:extLst>
      <p:ext uri="{BB962C8B-B14F-4D97-AF65-F5344CB8AC3E}">
        <p14:creationId xmlns:p14="http://schemas.microsoft.com/office/powerpoint/2010/main" val="220042652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81FF74-F85E-1B4D-835B-EF1AA8C13B22}" type="datetimeFigureOut">
              <a:rPr lang="en-CH" smtClean="0"/>
              <a:t>05.03.24</a:t>
            </a:fld>
            <a:endParaRPr lang="en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4EE2B1-B16D-1A43-A8B7-6D893387D606}" type="slidenum">
              <a:rPr lang="en-CH" smtClean="0"/>
              <a:t>‹#›</a:t>
            </a:fld>
            <a:endParaRPr lang="en-CH"/>
          </a:p>
        </p:txBody>
      </p:sp>
    </p:spTree>
    <p:extLst>
      <p:ext uri="{BB962C8B-B14F-4D97-AF65-F5344CB8AC3E}">
        <p14:creationId xmlns:p14="http://schemas.microsoft.com/office/powerpoint/2010/main" val="131320067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81FF74-F85E-1B4D-835B-EF1AA8C13B22}" type="datetimeFigureOut">
              <a:rPr lang="en-CH" smtClean="0"/>
              <a:t>05.03.24</a:t>
            </a:fld>
            <a:endParaRPr lang="en-CH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H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4EE2B1-B16D-1A43-A8B7-6D893387D606}" type="slidenum">
              <a:rPr lang="en-CH" smtClean="0"/>
              <a:t>‹#›</a:t>
            </a:fld>
            <a:endParaRPr lang="en-CH"/>
          </a:p>
        </p:txBody>
      </p:sp>
    </p:spTree>
    <p:extLst>
      <p:ext uri="{BB962C8B-B14F-4D97-AF65-F5344CB8AC3E}">
        <p14:creationId xmlns:p14="http://schemas.microsoft.com/office/powerpoint/2010/main" val="102248282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81FF74-F85E-1B4D-835B-EF1AA8C13B22}" type="datetimeFigureOut">
              <a:rPr lang="en-CH" smtClean="0"/>
              <a:t>05.03.24</a:t>
            </a:fld>
            <a:endParaRPr lang="en-CH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H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4EE2B1-B16D-1A43-A8B7-6D893387D606}" type="slidenum">
              <a:rPr lang="en-CH" smtClean="0"/>
              <a:t>‹#›</a:t>
            </a:fld>
            <a:endParaRPr lang="en-CH"/>
          </a:p>
        </p:txBody>
      </p:sp>
    </p:spTree>
    <p:extLst>
      <p:ext uri="{BB962C8B-B14F-4D97-AF65-F5344CB8AC3E}">
        <p14:creationId xmlns:p14="http://schemas.microsoft.com/office/powerpoint/2010/main" val="108587058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81FF74-F85E-1B4D-835B-EF1AA8C13B22}" type="datetimeFigureOut">
              <a:rPr lang="en-CH" smtClean="0"/>
              <a:t>05.03.24</a:t>
            </a:fld>
            <a:endParaRPr lang="en-CH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H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4EE2B1-B16D-1A43-A8B7-6D893387D606}" type="slidenum">
              <a:rPr lang="en-CH" smtClean="0"/>
              <a:t>‹#›</a:t>
            </a:fld>
            <a:endParaRPr lang="en-CH"/>
          </a:p>
        </p:txBody>
      </p:sp>
    </p:spTree>
    <p:extLst>
      <p:ext uri="{BB962C8B-B14F-4D97-AF65-F5344CB8AC3E}">
        <p14:creationId xmlns:p14="http://schemas.microsoft.com/office/powerpoint/2010/main" val="183195629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81FF74-F85E-1B4D-835B-EF1AA8C13B22}" type="datetimeFigureOut">
              <a:rPr lang="en-CH" smtClean="0"/>
              <a:t>05.03.24</a:t>
            </a:fld>
            <a:endParaRPr lang="en-CH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H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4EE2B1-B16D-1A43-A8B7-6D893387D606}" type="slidenum">
              <a:rPr lang="en-CH" smtClean="0"/>
              <a:t>‹#›</a:t>
            </a:fld>
            <a:endParaRPr lang="en-CH"/>
          </a:p>
        </p:txBody>
      </p:sp>
    </p:spTree>
    <p:extLst>
      <p:ext uri="{BB962C8B-B14F-4D97-AF65-F5344CB8AC3E}">
        <p14:creationId xmlns:p14="http://schemas.microsoft.com/office/powerpoint/2010/main" val="406237785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2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81FF74-F85E-1B4D-835B-EF1AA8C13B22}" type="datetimeFigureOut">
              <a:rPr lang="en-CH" smtClean="0"/>
              <a:t>05.03.24</a:t>
            </a:fld>
            <a:endParaRPr lang="en-CH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H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4EE2B1-B16D-1A43-A8B7-6D893387D606}" type="slidenum">
              <a:rPr lang="en-CH" smtClean="0"/>
              <a:t>‹#›</a:t>
            </a:fld>
            <a:endParaRPr lang="en-CH"/>
          </a:p>
        </p:txBody>
      </p:sp>
    </p:spTree>
    <p:extLst>
      <p:ext uri="{BB962C8B-B14F-4D97-AF65-F5344CB8AC3E}">
        <p14:creationId xmlns:p14="http://schemas.microsoft.com/office/powerpoint/2010/main" val="348059033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2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GB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81FF74-F85E-1B4D-835B-EF1AA8C13B22}" type="datetimeFigureOut">
              <a:rPr lang="en-CH" smtClean="0"/>
              <a:t>05.03.24</a:t>
            </a:fld>
            <a:endParaRPr lang="en-CH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H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4EE2B1-B16D-1A43-A8B7-6D893387D606}" type="slidenum">
              <a:rPr lang="en-CH" smtClean="0"/>
              <a:t>‹#›</a:t>
            </a:fld>
            <a:endParaRPr lang="en-CH"/>
          </a:p>
        </p:txBody>
      </p:sp>
    </p:spTree>
    <p:extLst>
      <p:ext uri="{BB962C8B-B14F-4D97-AF65-F5344CB8AC3E}">
        <p14:creationId xmlns:p14="http://schemas.microsoft.com/office/powerpoint/2010/main" val="92858336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7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781FF74-F85E-1B4D-835B-EF1AA8C13B22}" type="datetimeFigureOut">
              <a:rPr lang="en-CH" smtClean="0"/>
              <a:t>05.03.24</a:t>
            </a:fld>
            <a:endParaRPr lang="en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74EE2B1-B16D-1A43-A8B7-6D893387D606}" type="slidenum">
              <a:rPr lang="en-CH" smtClean="0"/>
              <a:t>‹#›</a:t>
            </a:fld>
            <a:endParaRPr lang="en-CH"/>
          </a:p>
        </p:txBody>
      </p:sp>
    </p:spTree>
    <p:extLst>
      <p:ext uri="{BB962C8B-B14F-4D97-AF65-F5344CB8AC3E}">
        <p14:creationId xmlns:p14="http://schemas.microsoft.com/office/powerpoint/2010/main" val="397775873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AAE5129F-548B-5DCA-8CC0-D6AFE95491D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157747233"/>
              </p:ext>
            </p:extLst>
          </p:nvPr>
        </p:nvGraphicFramePr>
        <p:xfrm>
          <a:off x="515302" y="396842"/>
          <a:ext cx="5827395" cy="5760720"/>
        </p:xfrm>
        <a:graphic>
          <a:graphicData uri="http://schemas.openxmlformats.org/drawingml/2006/table">
            <a:tbl>
              <a:tblPr firstRow="1" firstCol="1" bandRow="1">
                <a:tableStyleId>{F5AB1C69-6EDB-4FF4-983F-18BD219EF322}</a:tableStyleId>
              </a:tblPr>
              <a:tblGrid>
                <a:gridCol w="617855">
                  <a:extLst>
                    <a:ext uri="{9D8B030D-6E8A-4147-A177-3AD203B41FA5}">
                      <a16:colId xmlns:a16="http://schemas.microsoft.com/office/drawing/2014/main" val="1661888992"/>
                    </a:ext>
                  </a:extLst>
                </a:gridCol>
                <a:gridCol w="571500">
                  <a:extLst>
                    <a:ext uri="{9D8B030D-6E8A-4147-A177-3AD203B41FA5}">
                      <a16:colId xmlns:a16="http://schemas.microsoft.com/office/drawing/2014/main" val="247879022"/>
                    </a:ext>
                  </a:extLst>
                </a:gridCol>
                <a:gridCol w="1327785">
                  <a:extLst>
                    <a:ext uri="{9D8B030D-6E8A-4147-A177-3AD203B41FA5}">
                      <a16:colId xmlns:a16="http://schemas.microsoft.com/office/drawing/2014/main" val="3187375334"/>
                    </a:ext>
                  </a:extLst>
                </a:gridCol>
                <a:gridCol w="1001676">
                  <a:extLst>
                    <a:ext uri="{9D8B030D-6E8A-4147-A177-3AD203B41FA5}">
                      <a16:colId xmlns:a16="http://schemas.microsoft.com/office/drawing/2014/main" val="520061622"/>
                    </a:ext>
                  </a:extLst>
                </a:gridCol>
                <a:gridCol w="943739">
                  <a:extLst>
                    <a:ext uri="{9D8B030D-6E8A-4147-A177-3AD203B41FA5}">
                      <a16:colId xmlns:a16="http://schemas.microsoft.com/office/drawing/2014/main" val="3931021447"/>
                    </a:ext>
                  </a:extLst>
                </a:gridCol>
                <a:gridCol w="635679">
                  <a:extLst>
                    <a:ext uri="{9D8B030D-6E8A-4147-A177-3AD203B41FA5}">
                      <a16:colId xmlns:a16="http://schemas.microsoft.com/office/drawing/2014/main" val="2356175987"/>
                    </a:ext>
                  </a:extLst>
                </a:gridCol>
                <a:gridCol w="119561">
                  <a:extLst>
                    <a:ext uri="{9D8B030D-6E8A-4147-A177-3AD203B41FA5}">
                      <a16:colId xmlns:a16="http://schemas.microsoft.com/office/drawing/2014/main" val="4210618696"/>
                    </a:ext>
                  </a:extLst>
                </a:gridCol>
                <a:gridCol w="609600">
                  <a:extLst>
                    <a:ext uri="{9D8B030D-6E8A-4147-A177-3AD203B41FA5}">
                      <a16:colId xmlns:a16="http://schemas.microsoft.com/office/drawing/2014/main" val="1173856755"/>
                    </a:ext>
                  </a:extLst>
                </a:gridCol>
              </a:tblGrid>
              <a:tr h="30480">
                <a:tc gridSpan="8">
                  <a:txBody>
                    <a:bodyPr/>
                    <a:lstStyle/>
                    <a:p>
                      <a:pPr algn="ctr"/>
                      <a:r>
                        <a:rPr lang="en-US" sz="6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EALTHY DONORS</a:t>
                      </a:r>
                      <a:endParaRPr lang="en-CH" sz="8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en-CH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CH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CH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CH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CH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CH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CH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934509988"/>
                  </a:ext>
                </a:extLst>
              </a:tr>
              <a:tr h="30480">
                <a:tc>
                  <a:txBody>
                    <a:bodyPr/>
                    <a:lstStyle/>
                    <a:p>
                      <a:pPr algn="ctr"/>
                      <a:r>
                        <a:rPr lang="de-CH" sz="600" b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AMPLE ID</a:t>
                      </a:r>
                      <a:endParaRPr lang="en-CH" sz="800" b="1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CH" sz="600" b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IAGNOSIS</a:t>
                      </a:r>
                      <a:endParaRPr lang="en-CH" sz="800" b="1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CH" sz="600" b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AMPLE SOURCE</a:t>
                      </a:r>
                      <a:endParaRPr lang="en-CH" sz="800" b="1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CH" sz="600" b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S TREATMENT</a:t>
                      </a:r>
                      <a:endParaRPr lang="en-CH" sz="800" b="1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CH" sz="600" b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EX</a:t>
                      </a:r>
                      <a:endParaRPr lang="en-CH" sz="800" b="1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CH" sz="600" b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GE</a:t>
                      </a:r>
                      <a:endParaRPr lang="en-CH" sz="800" b="1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de-CH" sz="600" b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DSS SCORE</a:t>
                      </a:r>
                      <a:endParaRPr lang="en-CH" sz="800" b="1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/>
                      <a:r>
                        <a:rPr lang="de-CH" sz="600" b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DSS SCORE</a:t>
                      </a:r>
                      <a:endParaRPr lang="en-CH" sz="800" b="1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32703490"/>
                  </a:ext>
                </a:extLst>
              </a:tr>
              <a:tr h="30480">
                <a:tc>
                  <a:txBody>
                    <a:bodyPr/>
                    <a:lstStyle/>
                    <a:p>
                      <a:pPr algn="ctr"/>
                      <a:r>
                        <a:rPr lang="de-CH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D1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CH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A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CH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uffy coat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untreated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ale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7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de-CH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A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/>
                      <a:r>
                        <a:rPr lang="de-CH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A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24547768"/>
                  </a:ext>
                </a:extLst>
              </a:tr>
              <a:tr h="30480">
                <a:tc>
                  <a:txBody>
                    <a:bodyPr/>
                    <a:lstStyle/>
                    <a:p>
                      <a:pPr algn="ctr"/>
                      <a:r>
                        <a:rPr lang="de-CH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D2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CH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A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CH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uffy coat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untreated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ale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7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de-CH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A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/>
                      <a:r>
                        <a:rPr lang="de-CH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A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62878881"/>
                  </a:ext>
                </a:extLst>
              </a:tr>
              <a:tr h="30480">
                <a:tc>
                  <a:txBody>
                    <a:bodyPr/>
                    <a:lstStyle/>
                    <a:p>
                      <a:pPr algn="ctr"/>
                      <a:r>
                        <a:rPr lang="de-CH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D3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CH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A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CH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uffy coat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untreated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ale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6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de-CH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A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/>
                      <a:r>
                        <a:rPr lang="de-CH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A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66553147"/>
                  </a:ext>
                </a:extLst>
              </a:tr>
              <a:tr h="30480">
                <a:tc>
                  <a:txBody>
                    <a:bodyPr/>
                    <a:lstStyle/>
                    <a:p>
                      <a:pPr algn="ctr"/>
                      <a:r>
                        <a:rPr lang="de-CH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D4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CH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A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CH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uffy coat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untreated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ale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4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de-CH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A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/>
                      <a:r>
                        <a:rPr lang="de-CH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A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26611026"/>
                  </a:ext>
                </a:extLst>
              </a:tr>
              <a:tr h="30480">
                <a:tc>
                  <a:txBody>
                    <a:bodyPr/>
                    <a:lstStyle/>
                    <a:p>
                      <a:pPr algn="ctr"/>
                      <a:r>
                        <a:rPr lang="de-CH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D5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CH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A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CH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uffy coat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untreated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ale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6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de-CH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A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/>
                      <a:r>
                        <a:rPr lang="de-CH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A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86484041"/>
                  </a:ext>
                </a:extLst>
              </a:tr>
              <a:tr h="30480">
                <a:tc>
                  <a:txBody>
                    <a:bodyPr/>
                    <a:lstStyle/>
                    <a:p>
                      <a:pPr algn="ctr"/>
                      <a:r>
                        <a:rPr lang="de-CH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D6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CH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A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CH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uffy coat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untreated</a:t>
                      </a:r>
                      <a:endParaRPr lang="en-CH" sz="8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emale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3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de-CH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A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/>
                      <a:r>
                        <a:rPr lang="de-CH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A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52912788"/>
                  </a:ext>
                </a:extLst>
              </a:tr>
              <a:tr h="30480">
                <a:tc>
                  <a:txBody>
                    <a:bodyPr/>
                    <a:lstStyle/>
                    <a:p>
                      <a:pPr algn="ctr"/>
                      <a:r>
                        <a:rPr lang="de-CH" sz="6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D7</a:t>
                      </a:r>
                      <a:endParaRPr lang="en-CH" sz="8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CH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A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CH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uffy coat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untreated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emale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8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de-CH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A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/>
                      <a:r>
                        <a:rPr lang="de-CH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A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18736828"/>
                  </a:ext>
                </a:extLst>
              </a:tr>
              <a:tr h="30480">
                <a:tc>
                  <a:txBody>
                    <a:bodyPr/>
                    <a:lstStyle/>
                    <a:p>
                      <a:pPr algn="ctr"/>
                      <a:r>
                        <a:rPr lang="de-CH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D8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CH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A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CH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uffy coat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untreated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ale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7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de-CH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A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/>
                      <a:r>
                        <a:rPr lang="de-CH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A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29456040"/>
                  </a:ext>
                </a:extLst>
              </a:tr>
              <a:tr h="30480">
                <a:tc>
                  <a:txBody>
                    <a:bodyPr/>
                    <a:lstStyle/>
                    <a:p>
                      <a:pPr algn="ctr"/>
                      <a:r>
                        <a:rPr lang="de-CH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D9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CH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A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CH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uffy coat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untreated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emale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3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de-CH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A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/>
                      <a:r>
                        <a:rPr lang="de-CH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A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17213159"/>
                  </a:ext>
                </a:extLst>
              </a:tr>
              <a:tr h="30480">
                <a:tc>
                  <a:txBody>
                    <a:bodyPr/>
                    <a:lstStyle/>
                    <a:p>
                      <a:pPr algn="ctr"/>
                      <a:r>
                        <a:rPr lang="de-CH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D10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CH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A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ryopreserved PBMCs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untreated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ale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8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de-CH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A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/>
                      <a:r>
                        <a:rPr lang="de-CH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A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27701041"/>
                  </a:ext>
                </a:extLst>
              </a:tr>
              <a:tr h="30480">
                <a:tc>
                  <a:txBody>
                    <a:bodyPr/>
                    <a:lstStyle/>
                    <a:p>
                      <a:pPr algn="ctr"/>
                      <a:r>
                        <a:rPr lang="de-CH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D11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CH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A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ryopreserved PBMCs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untreated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emale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7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de-CH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A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/>
                      <a:r>
                        <a:rPr lang="de-CH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A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04862597"/>
                  </a:ext>
                </a:extLst>
              </a:tr>
              <a:tr h="30480">
                <a:tc>
                  <a:txBody>
                    <a:bodyPr/>
                    <a:lstStyle/>
                    <a:p>
                      <a:pPr algn="ctr"/>
                      <a:r>
                        <a:rPr lang="de-CH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D12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CH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A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ryopreserved PBMCs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untreated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emale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3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de-CH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A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/>
                      <a:r>
                        <a:rPr lang="de-CH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A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68685730"/>
                  </a:ext>
                </a:extLst>
              </a:tr>
              <a:tr h="47658">
                <a:tc>
                  <a:txBody>
                    <a:bodyPr/>
                    <a:lstStyle/>
                    <a:p>
                      <a:pPr algn="ctr"/>
                      <a:r>
                        <a:rPr lang="de-CH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D13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CH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A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ryopreserved PBMCs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untreated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ale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8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de-CH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A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/>
                      <a:r>
                        <a:rPr lang="de-CH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A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78285167"/>
                  </a:ext>
                </a:extLst>
              </a:tr>
              <a:tr h="30480">
                <a:tc>
                  <a:txBody>
                    <a:bodyPr/>
                    <a:lstStyle/>
                    <a:p>
                      <a:pPr algn="ctr"/>
                      <a:r>
                        <a:rPr lang="de-CH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D14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CH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A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ryopreserved PBMCs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untreated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emale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0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de-CH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A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/>
                      <a:r>
                        <a:rPr lang="de-CH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A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82882301"/>
                  </a:ext>
                </a:extLst>
              </a:tr>
              <a:tr h="43815">
                <a:tc>
                  <a:txBody>
                    <a:bodyPr/>
                    <a:lstStyle/>
                    <a:p>
                      <a:pPr algn="ctr"/>
                      <a:r>
                        <a:rPr lang="de-CH" sz="600" b="1" dirty="0">
                          <a:solidFill>
                            <a:srgbClr val="C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D15</a:t>
                      </a:r>
                      <a:endParaRPr lang="en-CH" sz="800" b="1" dirty="0">
                        <a:solidFill>
                          <a:srgbClr val="C0000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EC2B0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CH" sz="600" b="1">
                          <a:solidFill>
                            <a:srgbClr val="C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A</a:t>
                      </a:r>
                      <a:endParaRPr lang="en-CH" sz="800" b="1">
                        <a:solidFill>
                          <a:srgbClr val="C0000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EC2B0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 b="1" dirty="0">
                          <a:solidFill>
                            <a:srgbClr val="C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ryopreserved PBMCs</a:t>
                      </a:r>
                      <a:endParaRPr lang="en-CH" sz="800" b="1" dirty="0">
                        <a:solidFill>
                          <a:srgbClr val="C0000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EC2B0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 b="1" dirty="0">
                          <a:solidFill>
                            <a:srgbClr val="C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untreated</a:t>
                      </a:r>
                      <a:endParaRPr lang="en-CH" sz="800" b="1" dirty="0">
                        <a:solidFill>
                          <a:srgbClr val="C0000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EC2B0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 b="1">
                          <a:solidFill>
                            <a:srgbClr val="C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emale</a:t>
                      </a:r>
                      <a:endParaRPr lang="en-CH" sz="800" b="1" dirty="0">
                        <a:solidFill>
                          <a:srgbClr val="C0000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EC2B0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 b="1">
                          <a:solidFill>
                            <a:srgbClr val="C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6</a:t>
                      </a:r>
                      <a:endParaRPr lang="en-CH" sz="800" b="1" dirty="0">
                        <a:solidFill>
                          <a:srgbClr val="C0000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EC2B0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de-CH" sz="600" b="1">
                          <a:solidFill>
                            <a:srgbClr val="C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A</a:t>
                      </a:r>
                      <a:endParaRPr lang="en-CH" sz="800" b="1" dirty="0">
                        <a:solidFill>
                          <a:srgbClr val="C0000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EC2B0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/>
                      <a:r>
                        <a:rPr lang="de-CH" sz="600" b="1" dirty="0">
                          <a:solidFill>
                            <a:srgbClr val="C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A</a:t>
                      </a:r>
                      <a:endParaRPr lang="en-CH" sz="800" b="1" dirty="0">
                        <a:solidFill>
                          <a:srgbClr val="C0000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EC2B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1450345"/>
                  </a:ext>
                </a:extLst>
              </a:tr>
              <a:tr h="30480">
                <a:tc>
                  <a:txBody>
                    <a:bodyPr/>
                    <a:lstStyle/>
                    <a:p>
                      <a:pPr algn="ctr"/>
                      <a:r>
                        <a:rPr lang="de-CH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D16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CH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A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ryopreserved PBMCs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untreated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emale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9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de-CH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A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/>
                      <a:r>
                        <a:rPr lang="de-CH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A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66442478"/>
                  </a:ext>
                </a:extLst>
              </a:tr>
              <a:tr h="30480">
                <a:tc>
                  <a:txBody>
                    <a:bodyPr/>
                    <a:lstStyle/>
                    <a:p>
                      <a:pPr algn="ctr"/>
                      <a:r>
                        <a:rPr lang="de-CH" sz="6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D17</a:t>
                      </a:r>
                      <a:endParaRPr lang="en-CH" sz="8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CH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A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ryopreserved PBMCs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untreated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emale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2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de-CH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A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/>
                      <a:r>
                        <a:rPr lang="de-CH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A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07382015"/>
                  </a:ext>
                </a:extLst>
              </a:tr>
              <a:tr h="30480">
                <a:tc>
                  <a:txBody>
                    <a:bodyPr/>
                    <a:lstStyle/>
                    <a:p>
                      <a:pPr algn="ctr"/>
                      <a:r>
                        <a:rPr lang="de-CH" sz="600" b="1" dirty="0">
                          <a:solidFill>
                            <a:srgbClr val="C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D18</a:t>
                      </a:r>
                      <a:endParaRPr lang="en-CH" sz="800" b="1" dirty="0">
                        <a:solidFill>
                          <a:srgbClr val="C0000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EC2B0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CH" sz="600" b="1" dirty="0">
                          <a:solidFill>
                            <a:srgbClr val="C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A</a:t>
                      </a:r>
                      <a:endParaRPr lang="en-CH" sz="800" b="1" dirty="0">
                        <a:solidFill>
                          <a:srgbClr val="C0000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EC2B0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 b="1" dirty="0">
                          <a:solidFill>
                            <a:srgbClr val="C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ryopreserved PBMCs</a:t>
                      </a:r>
                      <a:endParaRPr lang="en-CH" sz="800" b="1" dirty="0">
                        <a:solidFill>
                          <a:srgbClr val="C0000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EC2B0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 b="1" dirty="0">
                          <a:solidFill>
                            <a:srgbClr val="C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untreated</a:t>
                      </a:r>
                      <a:endParaRPr lang="en-CH" sz="800" b="1" dirty="0">
                        <a:solidFill>
                          <a:srgbClr val="C0000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EC2B0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 b="1">
                          <a:solidFill>
                            <a:srgbClr val="C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emale</a:t>
                      </a:r>
                      <a:endParaRPr lang="en-CH" sz="800" b="1" dirty="0">
                        <a:solidFill>
                          <a:srgbClr val="C0000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EC2B0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 b="1">
                          <a:solidFill>
                            <a:srgbClr val="C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6</a:t>
                      </a:r>
                      <a:endParaRPr lang="en-CH" sz="800" b="1" dirty="0">
                        <a:solidFill>
                          <a:srgbClr val="C0000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EC2B0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de-CH" sz="600" b="1">
                          <a:solidFill>
                            <a:srgbClr val="C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A</a:t>
                      </a:r>
                      <a:endParaRPr lang="en-CH" sz="800" b="1" dirty="0">
                        <a:solidFill>
                          <a:srgbClr val="C0000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EC2B0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/>
                      <a:r>
                        <a:rPr lang="de-CH" sz="600" b="1" dirty="0">
                          <a:solidFill>
                            <a:srgbClr val="C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A</a:t>
                      </a:r>
                      <a:endParaRPr lang="en-CH" sz="800" b="1" dirty="0">
                        <a:solidFill>
                          <a:srgbClr val="C0000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EC2B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615669870"/>
                  </a:ext>
                </a:extLst>
              </a:tr>
              <a:tr h="101600">
                <a:tc>
                  <a:txBody>
                    <a:bodyPr/>
                    <a:lstStyle/>
                    <a:p>
                      <a:pPr algn="ctr"/>
                      <a:r>
                        <a:rPr lang="en-US" sz="6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ummary</a:t>
                      </a:r>
                      <a:endParaRPr lang="en-CH" sz="8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/>
                      <a:r>
                        <a:rPr lang="en-US" sz="6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n = 16)</a:t>
                      </a:r>
                      <a:endParaRPr lang="en-CH" sz="8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A</a:t>
                      </a:r>
                      <a:endParaRPr lang="en-CH" sz="8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x Buffy coat</a:t>
                      </a:r>
                      <a:endParaRPr lang="en-CH" sz="8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/>
                      <a:r>
                        <a:rPr lang="en-US" sz="6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x Cryopreserved PBMCs</a:t>
                      </a:r>
                      <a:endParaRPr lang="en-CH" sz="8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ll untreated</a:t>
                      </a:r>
                      <a:endParaRPr lang="en-CH" sz="8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x female</a:t>
                      </a:r>
                      <a:endParaRPr lang="en-CH" sz="8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/>
                      <a:r>
                        <a:rPr lang="en-US" sz="6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x male</a:t>
                      </a:r>
                      <a:endParaRPr lang="en-CH" sz="8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ean = 37</a:t>
                      </a:r>
                      <a:endParaRPr lang="en-CH" sz="8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6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A</a:t>
                      </a:r>
                      <a:endParaRPr lang="en-CH" sz="8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/>
                      <a:r>
                        <a:rPr lang="en-US" sz="6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A</a:t>
                      </a:r>
                      <a:endParaRPr lang="en-CH" sz="8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68865401"/>
                  </a:ext>
                </a:extLst>
              </a:tr>
              <a:tr h="30480">
                <a:tc gridSpan="8">
                  <a:txBody>
                    <a:bodyPr/>
                    <a:lstStyle/>
                    <a:p>
                      <a:pPr algn="ctr"/>
                      <a:r>
                        <a:rPr lang="en-US" sz="6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UNTREATED RRMS PATIENTS</a:t>
                      </a:r>
                      <a:endParaRPr lang="en-CH" sz="8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en-CH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CH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CH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CH"/>
                    </a:p>
                  </a:txBody>
                  <a:tcPr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hMerge="1">
                  <a:txBody>
                    <a:bodyPr/>
                    <a:lstStyle/>
                    <a:p>
                      <a:endParaRPr lang="en-CH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CH"/>
                    </a:p>
                  </a:txBody>
                  <a:tcPr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hMerge="1">
                  <a:txBody>
                    <a:bodyPr/>
                    <a:lstStyle/>
                    <a:p>
                      <a:endParaRPr lang="en-CH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527930102"/>
                  </a:ext>
                </a:extLst>
              </a:tr>
              <a:tr h="30480">
                <a:tc>
                  <a:txBody>
                    <a:bodyPr/>
                    <a:lstStyle/>
                    <a:p>
                      <a:pPr algn="ctr"/>
                      <a:r>
                        <a:rPr lang="de-CH" sz="600" b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AMPLE ID</a:t>
                      </a:r>
                      <a:endParaRPr lang="en-CH" sz="800" b="1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CH" sz="600" b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IAGNOSIS</a:t>
                      </a:r>
                      <a:endParaRPr lang="en-CH" sz="800" b="1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CH" sz="600" b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AMPLE SOURCE</a:t>
                      </a:r>
                      <a:endParaRPr lang="en-CH" sz="800" b="1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CH" sz="600" b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S TREATMENT</a:t>
                      </a:r>
                      <a:endParaRPr lang="en-CH" sz="800" b="1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CH" sz="600" b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EX</a:t>
                      </a:r>
                      <a:endParaRPr lang="en-CH" dirty="0"/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CH" sz="600" b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GE</a:t>
                      </a:r>
                      <a:endParaRPr lang="en-CH" sz="8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de-CH" sz="600" b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DSS SCORE</a:t>
                      </a:r>
                      <a:endParaRPr lang="en-CH" sz="8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/>
                      <a:r>
                        <a:rPr lang="de-CH" sz="600" b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DSS SCORE</a:t>
                      </a:r>
                      <a:endParaRPr lang="en-CH" sz="800" b="1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77498331"/>
                  </a:ext>
                </a:extLst>
              </a:tr>
              <a:tr h="30480"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RMS1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CH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RMS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ryopreserved PBMCs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untreated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emale</a:t>
                      </a:r>
                      <a:endParaRPr lang="en-CH" dirty="0"/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9</a:t>
                      </a:r>
                      <a:endParaRPr lang="en-CH" sz="8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6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endParaRPr lang="en-CH" sz="8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92421080"/>
                  </a:ext>
                </a:extLst>
              </a:tr>
              <a:tr h="30480"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RMS2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RMS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ryopreserved PBMCs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untreated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ale</a:t>
                      </a:r>
                      <a:endParaRPr lang="en-CH"/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6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86501951"/>
                  </a:ext>
                </a:extLst>
              </a:tr>
              <a:tr h="30480"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RMS3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RMS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ryopreserved PBMCs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untreated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emale</a:t>
                      </a:r>
                      <a:endParaRPr lang="en-CH"/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9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97201829"/>
                  </a:ext>
                </a:extLst>
              </a:tr>
              <a:tr h="30480"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RMS4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RMS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ryopreserved PBMCs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untreated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emale</a:t>
                      </a:r>
                      <a:endParaRPr lang="en-CH" dirty="0"/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7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5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5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24719193"/>
                  </a:ext>
                </a:extLst>
              </a:tr>
              <a:tr h="30480"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RMS5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RMS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ryopreserved PBMCs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untreated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emale</a:t>
                      </a:r>
                      <a:endParaRPr lang="en-CH"/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3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97965092"/>
                  </a:ext>
                </a:extLst>
              </a:tr>
              <a:tr h="30480"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RMS6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CH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RMS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ryopreserved PBMCs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untreated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emale</a:t>
                      </a:r>
                      <a:endParaRPr lang="en-CH"/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4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5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5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38228912"/>
                  </a:ext>
                </a:extLst>
              </a:tr>
              <a:tr h="30480"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RMS7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CH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RMS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ryopreserved PBMCs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untreated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ale</a:t>
                      </a:r>
                      <a:endParaRPr lang="en-CH"/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4</a:t>
                      </a:r>
                      <a:endParaRPr lang="en-CH" sz="8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77011778"/>
                  </a:ext>
                </a:extLst>
              </a:tr>
              <a:tr h="30480"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RMS8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CH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RMS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ryopreserved PBMCs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untreated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ale</a:t>
                      </a:r>
                      <a:endParaRPr lang="en-CH" dirty="0"/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4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3130557"/>
                  </a:ext>
                </a:extLst>
              </a:tr>
              <a:tr h="30480"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RMS9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CH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RMS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ryopreserved PBMCs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untreated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ale</a:t>
                      </a:r>
                      <a:endParaRPr lang="en-CH"/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6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50672767"/>
                  </a:ext>
                </a:extLst>
              </a:tr>
              <a:tr h="30480"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RMS10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CH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RMS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ryopreserved PBMCs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untreated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emale</a:t>
                      </a:r>
                      <a:endParaRPr lang="en-CH"/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3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14746595"/>
                  </a:ext>
                </a:extLst>
              </a:tr>
              <a:tr h="30480"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RMS11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CH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RMS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ryopreserved PBMCs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untreated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ale</a:t>
                      </a:r>
                      <a:endParaRPr lang="en-CH"/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6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27889013"/>
                  </a:ext>
                </a:extLst>
              </a:tr>
              <a:tr h="30480"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RMS12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CH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RMS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ryopreserved PBMCs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untreated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emale</a:t>
                      </a:r>
                      <a:endParaRPr lang="en-CH"/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4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93406733"/>
                  </a:ext>
                </a:extLst>
              </a:tr>
              <a:tr h="40005"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RMS13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CH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RMS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ryopreserved PBMCs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untreated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ale</a:t>
                      </a:r>
                      <a:endParaRPr lang="en-CH"/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0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41280744"/>
                  </a:ext>
                </a:extLst>
              </a:tr>
              <a:tr h="30480"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RMS14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CH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RMS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ryopreserved PBMCs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untreated</a:t>
                      </a:r>
                      <a:endParaRPr lang="en-CH" sz="8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ale</a:t>
                      </a:r>
                      <a:endParaRPr lang="en-CH"/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5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41203006"/>
                  </a:ext>
                </a:extLst>
              </a:tr>
              <a:tr h="30480"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RMS15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CH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RMS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ryopreserved PBMCs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untreated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emale</a:t>
                      </a:r>
                      <a:endParaRPr lang="en-CH"/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5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5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5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48994660"/>
                  </a:ext>
                </a:extLst>
              </a:tr>
              <a:tr h="30480"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RMS16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CH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RMS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ryopreserved PBMCs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untreated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ale</a:t>
                      </a:r>
                      <a:endParaRPr lang="en-CH"/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2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49731235"/>
                  </a:ext>
                </a:extLst>
              </a:tr>
              <a:tr h="30480">
                <a:tc>
                  <a:txBody>
                    <a:bodyPr/>
                    <a:lstStyle/>
                    <a:p>
                      <a:pPr algn="ctr"/>
                      <a:r>
                        <a:rPr lang="en-US" sz="600" b="1" dirty="0">
                          <a:solidFill>
                            <a:srgbClr val="C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RMS17</a:t>
                      </a:r>
                      <a:endParaRPr lang="en-CH" sz="800" b="1" dirty="0">
                        <a:solidFill>
                          <a:srgbClr val="C0000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EC2B0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CH" sz="600" b="1" dirty="0">
                          <a:solidFill>
                            <a:srgbClr val="C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RMS</a:t>
                      </a:r>
                      <a:endParaRPr lang="en-CH" sz="800" b="1" dirty="0">
                        <a:solidFill>
                          <a:srgbClr val="C0000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EC2B0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 b="1" dirty="0">
                          <a:solidFill>
                            <a:srgbClr val="C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ryopreserved PBMCs</a:t>
                      </a:r>
                      <a:endParaRPr lang="en-CH" sz="800" b="1" dirty="0">
                        <a:solidFill>
                          <a:srgbClr val="C0000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EC2B0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 b="1" dirty="0">
                          <a:solidFill>
                            <a:srgbClr val="C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untreated</a:t>
                      </a:r>
                      <a:endParaRPr lang="en-CH" sz="800" b="1" dirty="0">
                        <a:solidFill>
                          <a:srgbClr val="C0000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EC2B0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 b="1">
                          <a:solidFill>
                            <a:srgbClr val="C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emale</a:t>
                      </a:r>
                      <a:endParaRPr lang="en-CH"/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EC2B0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 b="1">
                          <a:solidFill>
                            <a:srgbClr val="C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2</a:t>
                      </a:r>
                      <a:endParaRPr lang="en-CH" sz="800" b="1" dirty="0">
                        <a:solidFill>
                          <a:srgbClr val="C0000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EC2B0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600" b="1">
                          <a:solidFill>
                            <a:srgbClr val="C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CH" sz="800" b="1" dirty="0">
                        <a:solidFill>
                          <a:srgbClr val="C0000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EC2B0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/>
                      <a:r>
                        <a:rPr lang="en-US" sz="600" b="1" dirty="0">
                          <a:solidFill>
                            <a:srgbClr val="C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CH" sz="800" b="1" dirty="0">
                        <a:solidFill>
                          <a:srgbClr val="C0000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EC2B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622648287"/>
                  </a:ext>
                </a:extLst>
              </a:tr>
              <a:tr h="30480"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RMS18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CH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RMS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ryopreserved PBMCs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untreated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emale</a:t>
                      </a:r>
                      <a:endParaRPr lang="en-CH"/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3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/>
                      <a:r>
                        <a:rPr lang="en-US" sz="6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CH" sz="8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13949719"/>
                  </a:ext>
                </a:extLst>
              </a:tr>
              <a:tr h="30480"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RMS19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CH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RMS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ryopreserved PBMCs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untreated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ale</a:t>
                      </a:r>
                      <a:endParaRPr lang="en-CH"/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1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24216842"/>
                  </a:ext>
                </a:extLst>
              </a:tr>
              <a:tr h="30480">
                <a:tc>
                  <a:txBody>
                    <a:bodyPr/>
                    <a:lstStyle/>
                    <a:p>
                      <a:pPr algn="ctr"/>
                      <a:r>
                        <a:rPr lang="de-CH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RMS20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CH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RMS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ryopreserved PBMCs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untreated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emale</a:t>
                      </a:r>
                      <a:endParaRPr lang="en-CH"/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8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5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5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17419345"/>
                  </a:ext>
                </a:extLst>
              </a:tr>
              <a:tr h="101600">
                <a:tc>
                  <a:txBody>
                    <a:bodyPr/>
                    <a:lstStyle/>
                    <a:p>
                      <a:pPr algn="ctr"/>
                      <a:r>
                        <a:rPr lang="en-US" sz="6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ummary</a:t>
                      </a:r>
                      <a:endParaRPr lang="en-CH" sz="8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/>
                      <a:r>
                        <a:rPr lang="en-US" sz="6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n = 19)</a:t>
                      </a:r>
                      <a:endParaRPr lang="en-CH" sz="8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CH" sz="6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ll RRMS</a:t>
                      </a:r>
                      <a:endParaRPr lang="en-CH" sz="8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ll cryopreserved PBMCs</a:t>
                      </a:r>
                      <a:endParaRPr lang="en-CH" sz="8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ll untreated</a:t>
                      </a:r>
                      <a:endParaRPr lang="en-CH" sz="8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x female</a:t>
                      </a:r>
                      <a:endParaRPr lang="en-CH" sz="8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/>
                      <a:r>
                        <a:rPr lang="en-US" sz="6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x male</a:t>
                      </a:r>
                      <a:endParaRPr lang="en-CH" dirty="0"/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ean = 37</a:t>
                      </a:r>
                      <a:endParaRPr lang="en-CH" sz="8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6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ean = 1.3</a:t>
                      </a:r>
                      <a:endParaRPr lang="en-CH" sz="8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ean = 1.3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55643317"/>
                  </a:ext>
                </a:extLst>
              </a:tr>
              <a:tr h="30480">
                <a:tc gridSpan="8">
                  <a:txBody>
                    <a:bodyPr/>
                    <a:lstStyle/>
                    <a:p>
                      <a:pPr algn="ctr"/>
                      <a:r>
                        <a:rPr lang="en-US" sz="6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AT-TREATED RRMS PATIENTS</a:t>
                      </a:r>
                      <a:endParaRPr lang="en-CH" sz="8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en-CH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CH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CH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CH"/>
                    </a:p>
                  </a:txBody>
                  <a:tcPr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hMerge="1">
                  <a:txBody>
                    <a:bodyPr/>
                    <a:lstStyle/>
                    <a:p>
                      <a:endParaRPr lang="en-CH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CH"/>
                    </a:p>
                  </a:txBody>
                  <a:tcPr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hMerge="1">
                  <a:txBody>
                    <a:bodyPr/>
                    <a:lstStyle/>
                    <a:p>
                      <a:endParaRPr lang="en-CH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018792305"/>
                  </a:ext>
                </a:extLst>
              </a:tr>
              <a:tr h="30480">
                <a:tc>
                  <a:txBody>
                    <a:bodyPr/>
                    <a:lstStyle/>
                    <a:p>
                      <a:pPr algn="ctr"/>
                      <a:r>
                        <a:rPr lang="de-CH" sz="600" b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AMPLE ID</a:t>
                      </a:r>
                      <a:endParaRPr lang="en-CH" sz="800" b="1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CH" sz="600" b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IAGNOSIS</a:t>
                      </a:r>
                      <a:endParaRPr lang="en-CH" sz="800" b="1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CH" sz="600" b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AMPLE SOURCE</a:t>
                      </a:r>
                      <a:endParaRPr lang="en-CH" sz="800" b="1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CH" sz="600" b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S TREATMENT</a:t>
                      </a:r>
                      <a:endParaRPr lang="en-CH" sz="800" b="1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CH" sz="600" b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EX</a:t>
                      </a:r>
                      <a:endParaRPr lang="en-CH" dirty="0"/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de-CH" sz="600" b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GE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CH" sz="600" b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DSS SCORE</a:t>
                      </a:r>
                      <a:endParaRPr lang="en-CH" sz="800" b="1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01007891"/>
                  </a:ext>
                </a:extLst>
              </a:tr>
              <a:tr h="30480">
                <a:tc>
                  <a:txBody>
                    <a:bodyPr/>
                    <a:lstStyle/>
                    <a:p>
                      <a:pPr algn="ctr"/>
                      <a:r>
                        <a:rPr lang="en-US" sz="600" b="1" dirty="0">
                          <a:solidFill>
                            <a:srgbClr val="C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AT1</a:t>
                      </a:r>
                      <a:endParaRPr lang="en-CH" sz="800" b="1" dirty="0">
                        <a:solidFill>
                          <a:srgbClr val="C0000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EC2B0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CH" sz="600" b="1" dirty="0">
                          <a:solidFill>
                            <a:srgbClr val="C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RMS</a:t>
                      </a:r>
                      <a:endParaRPr lang="en-CH" sz="800" b="1" dirty="0">
                        <a:solidFill>
                          <a:srgbClr val="C0000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EC2B0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 b="1" dirty="0">
                          <a:solidFill>
                            <a:srgbClr val="C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ryopreserved PBMCs</a:t>
                      </a:r>
                      <a:endParaRPr lang="en-CH" sz="800" b="1" dirty="0">
                        <a:solidFill>
                          <a:srgbClr val="C0000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EC2B0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 b="1" dirty="0">
                          <a:solidFill>
                            <a:srgbClr val="C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AT</a:t>
                      </a:r>
                      <a:endParaRPr lang="en-CH" sz="800" b="1" dirty="0">
                        <a:solidFill>
                          <a:srgbClr val="C0000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EC2B0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 b="1">
                          <a:solidFill>
                            <a:srgbClr val="C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emale</a:t>
                      </a:r>
                      <a:endParaRPr lang="en-CH"/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EC2B0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600" b="1">
                          <a:solidFill>
                            <a:srgbClr val="C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6</a:t>
                      </a:r>
                      <a:endParaRPr lang="en-CH" sz="800" b="1" dirty="0">
                        <a:solidFill>
                          <a:srgbClr val="C0000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EC2B0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CH" sz="800" b="1" dirty="0">
                        <a:solidFill>
                          <a:srgbClr val="C0000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EC2B0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 b="1" dirty="0">
                          <a:solidFill>
                            <a:srgbClr val="C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</a:t>
                      </a:r>
                      <a:endParaRPr lang="en-CH" sz="800" b="1" dirty="0">
                        <a:solidFill>
                          <a:srgbClr val="C0000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EC2B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290017226"/>
                  </a:ext>
                </a:extLst>
              </a:tr>
              <a:tr h="30480"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AT2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CH" sz="6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RMS</a:t>
                      </a:r>
                      <a:endParaRPr lang="en-CH" sz="8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ryopreserved PBMCs</a:t>
                      </a:r>
                      <a:endParaRPr lang="en-CH" sz="8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AT</a:t>
                      </a:r>
                      <a:endParaRPr lang="en-CH" sz="8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ale</a:t>
                      </a:r>
                      <a:endParaRPr lang="en-CH" dirty="0"/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6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50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65508731"/>
                  </a:ext>
                </a:extLst>
              </a:tr>
              <a:tr h="30480"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AT3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CH" sz="6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RMS</a:t>
                      </a:r>
                      <a:endParaRPr lang="en-CH" sz="8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ryopreserved PBMCs</a:t>
                      </a:r>
                      <a:endParaRPr lang="en-CH" sz="8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AT</a:t>
                      </a:r>
                      <a:endParaRPr lang="en-CH" sz="8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ale</a:t>
                      </a:r>
                      <a:endParaRPr lang="en-CH" dirty="0"/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6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00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17189877"/>
                  </a:ext>
                </a:extLst>
              </a:tr>
              <a:tr h="30480"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AT4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CH" sz="6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RMS</a:t>
                      </a:r>
                      <a:endParaRPr lang="en-CH" sz="8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ryopreserved PBMCs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AT</a:t>
                      </a:r>
                      <a:endParaRPr lang="en-CH" sz="8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emale</a:t>
                      </a:r>
                      <a:endParaRPr lang="en-CH"/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4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50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2432787"/>
                  </a:ext>
                </a:extLst>
              </a:tr>
              <a:tr h="30480"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AT5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CH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RMS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ryopreserved PBMCs</a:t>
                      </a:r>
                      <a:endParaRPr lang="en-CH" sz="8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AT</a:t>
                      </a:r>
                      <a:endParaRPr lang="en-CH" sz="8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emale</a:t>
                      </a:r>
                      <a:endParaRPr lang="en-CH"/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2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A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95786412"/>
                  </a:ext>
                </a:extLst>
              </a:tr>
              <a:tr h="30480"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AT6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CH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RMS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ryopreserved PBMCs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AT</a:t>
                      </a:r>
                      <a:endParaRPr lang="en-CH" sz="8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emale</a:t>
                      </a:r>
                      <a:endParaRPr lang="en-CH" dirty="0"/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3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00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67968158"/>
                  </a:ext>
                </a:extLst>
              </a:tr>
              <a:tr h="30480"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AT7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CH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RMS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ryopreserved PBMCs</a:t>
                      </a:r>
                      <a:endParaRPr lang="en-CH" sz="8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AT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ale</a:t>
                      </a:r>
                      <a:endParaRPr lang="en-CH"/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5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00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87297385"/>
                  </a:ext>
                </a:extLst>
              </a:tr>
              <a:tr h="30480"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AT8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CH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RMS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ryopreserved PBMCs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AT</a:t>
                      </a:r>
                      <a:endParaRPr lang="en-CH" sz="8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emale</a:t>
                      </a:r>
                      <a:endParaRPr lang="en-CH" dirty="0"/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4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00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9178525"/>
                  </a:ext>
                </a:extLst>
              </a:tr>
              <a:tr h="30480">
                <a:tc>
                  <a:txBody>
                    <a:bodyPr/>
                    <a:lstStyle/>
                    <a:p>
                      <a:pPr algn="ctr"/>
                      <a:r>
                        <a:rPr lang="en-US" sz="600" b="1" dirty="0">
                          <a:solidFill>
                            <a:srgbClr val="C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AT9</a:t>
                      </a:r>
                      <a:endParaRPr lang="en-CH" sz="800" b="1" dirty="0">
                        <a:solidFill>
                          <a:srgbClr val="C0000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EC2B0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CH" sz="600" b="1" dirty="0">
                          <a:solidFill>
                            <a:srgbClr val="C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RMS</a:t>
                      </a:r>
                      <a:endParaRPr lang="en-CH" sz="800" b="1" dirty="0">
                        <a:solidFill>
                          <a:srgbClr val="C0000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EC2B0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 b="1" dirty="0">
                          <a:solidFill>
                            <a:srgbClr val="C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ryopreserved PBMCs</a:t>
                      </a:r>
                      <a:endParaRPr lang="en-CH" sz="800" b="1" dirty="0">
                        <a:solidFill>
                          <a:srgbClr val="C0000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EC2B0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 b="1" dirty="0">
                          <a:solidFill>
                            <a:srgbClr val="C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AT</a:t>
                      </a:r>
                      <a:endParaRPr lang="en-CH" sz="800" b="1" dirty="0">
                        <a:solidFill>
                          <a:srgbClr val="C0000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EC2B0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 b="1" dirty="0">
                          <a:solidFill>
                            <a:srgbClr val="C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emale</a:t>
                      </a:r>
                      <a:endParaRPr lang="en-CH" dirty="0"/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EC2B0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600" b="1">
                          <a:solidFill>
                            <a:srgbClr val="C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5</a:t>
                      </a:r>
                      <a:endParaRPr lang="en-CH" sz="800" b="1" dirty="0">
                        <a:solidFill>
                          <a:srgbClr val="C0000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EC2B0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CH" sz="800" b="1" dirty="0">
                        <a:solidFill>
                          <a:srgbClr val="C0000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EC2B0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 b="1" dirty="0">
                          <a:solidFill>
                            <a:srgbClr val="C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  <a:endParaRPr lang="en-CH" sz="800" b="1" dirty="0">
                        <a:solidFill>
                          <a:srgbClr val="C0000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EC2B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868290735"/>
                  </a:ext>
                </a:extLst>
              </a:tr>
              <a:tr h="30480"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AT10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CH" sz="6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RMS</a:t>
                      </a:r>
                      <a:endParaRPr lang="en-CH" sz="8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ryopreserved PBMCs</a:t>
                      </a:r>
                      <a:endParaRPr lang="en-CH" sz="8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AT</a:t>
                      </a:r>
                      <a:endParaRPr lang="en-CH" sz="8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emale</a:t>
                      </a:r>
                      <a:endParaRPr lang="en-CH" dirty="0"/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5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01373326"/>
                  </a:ext>
                </a:extLst>
              </a:tr>
              <a:tr h="30480"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AT11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CH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RMS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eukapheresis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AT</a:t>
                      </a:r>
                      <a:endParaRPr lang="en-CH" sz="8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ale</a:t>
                      </a:r>
                      <a:endParaRPr lang="en-CH" dirty="0"/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8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0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82484894"/>
                  </a:ext>
                </a:extLst>
              </a:tr>
              <a:tr h="30480"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AT12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CH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RMS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ryopreserved PBMCs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AT</a:t>
                      </a:r>
                      <a:endParaRPr lang="en-CH" sz="8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emale</a:t>
                      </a:r>
                      <a:endParaRPr lang="en-CH" dirty="0"/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0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00</a:t>
                      </a:r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94972661"/>
                  </a:ext>
                </a:extLst>
              </a:tr>
              <a:tr h="30480">
                <a:tc>
                  <a:txBody>
                    <a:bodyPr/>
                    <a:lstStyle/>
                    <a:p>
                      <a:pPr algn="ctr"/>
                      <a:r>
                        <a:rPr lang="en-US" sz="6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ummary</a:t>
                      </a:r>
                      <a:endParaRPr lang="en-CH" sz="8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/>
                      <a:r>
                        <a:rPr lang="en-US" sz="6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n = 10)</a:t>
                      </a:r>
                      <a:endParaRPr lang="en-CH" sz="8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CH" sz="6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ll RRMS</a:t>
                      </a:r>
                      <a:endParaRPr lang="en-CH" sz="8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x Cryopreserved PBMCs</a:t>
                      </a:r>
                      <a:endParaRPr lang="en-CH" sz="8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/>
                      <a:r>
                        <a:rPr lang="en-US" sz="6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x Leukapheresis</a:t>
                      </a:r>
                      <a:endParaRPr lang="en-CH" sz="8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ll natalizumab</a:t>
                      </a:r>
                      <a:endParaRPr lang="en-CH" sz="8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x female</a:t>
                      </a:r>
                      <a:endParaRPr lang="en-CH" sz="8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/>
                      <a:r>
                        <a:rPr lang="en-US" sz="6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x male</a:t>
                      </a:r>
                      <a:endParaRPr lang="en-CH" dirty="0"/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6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ean = 36</a:t>
                      </a:r>
                      <a:endParaRPr lang="en-CH" sz="8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CH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ean = 2.8</a:t>
                      </a:r>
                      <a:endParaRPr lang="en-CH" sz="8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37291070"/>
                  </a:ext>
                </a:extLst>
              </a:tr>
            </a:tbl>
          </a:graphicData>
        </a:graphic>
      </p:graphicFrame>
      <p:graphicFrame>
        <p:nvGraphicFramePr>
          <p:cNvPr id="7" name="Table 6">
            <a:extLst>
              <a:ext uri="{FF2B5EF4-FFF2-40B4-BE49-F238E27FC236}">
                <a16:creationId xmlns:a16="http://schemas.microsoft.com/office/drawing/2014/main" id="{81E3F351-2CFA-C3CD-6842-250A0D9C192E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783854845"/>
              </p:ext>
            </p:extLst>
          </p:nvPr>
        </p:nvGraphicFramePr>
        <p:xfrm>
          <a:off x="515299" y="6203089"/>
          <a:ext cx="5827391" cy="2244142"/>
        </p:xfrm>
        <a:graphic>
          <a:graphicData uri="http://schemas.openxmlformats.org/drawingml/2006/table">
            <a:tbl>
              <a:tblPr firstRow="1" firstCol="1" bandRow="1">
                <a:tableStyleId>{F5AB1C69-6EDB-4FF4-983F-18BD219EF322}</a:tableStyleId>
              </a:tblPr>
              <a:tblGrid>
                <a:gridCol w="572936">
                  <a:extLst>
                    <a:ext uri="{9D8B030D-6E8A-4147-A177-3AD203B41FA5}">
                      <a16:colId xmlns:a16="http://schemas.microsoft.com/office/drawing/2014/main" val="3183364812"/>
                    </a:ext>
                  </a:extLst>
                </a:gridCol>
                <a:gridCol w="625854">
                  <a:extLst>
                    <a:ext uri="{9D8B030D-6E8A-4147-A177-3AD203B41FA5}">
                      <a16:colId xmlns:a16="http://schemas.microsoft.com/office/drawing/2014/main" val="3108699481"/>
                    </a:ext>
                  </a:extLst>
                </a:gridCol>
                <a:gridCol w="632785">
                  <a:extLst>
                    <a:ext uri="{9D8B030D-6E8A-4147-A177-3AD203B41FA5}">
                      <a16:colId xmlns:a16="http://schemas.microsoft.com/office/drawing/2014/main" val="258041715"/>
                    </a:ext>
                  </a:extLst>
                </a:gridCol>
                <a:gridCol w="505458">
                  <a:extLst>
                    <a:ext uri="{9D8B030D-6E8A-4147-A177-3AD203B41FA5}">
                      <a16:colId xmlns:a16="http://schemas.microsoft.com/office/drawing/2014/main" val="1276715189"/>
                    </a:ext>
                  </a:extLst>
                </a:gridCol>
                <a:gridCol w="635511">
                  <a:extLst>
                    <a:ext uri="{9D8B030D-6E8A-4147-A177-3AD203B41FA5}">
                      <a16:colId xmlns:a16="http://schemas.microsoft.com/office/drawing/2014/main" val="622080356"/>
                    </a:ext>
                  </a:extLst>
                </a:gridCol>
                <a:gridCol w="798447">
                  <a:extLst>
                    <a:ext uri="{9D8B030D-6E8A-4147-A177-3AD203B41FA5}">
                      <a16:colId xmlns:a16="http://schemas.microsoft.com/office/drawing/2014/main" val="1881011563"/>
                    </a:ext>
                  </a:extLst>
                </a:gridCol>
                <a:gridCol w="342500">
                  <a:extLst>
                    <a:ext uri="{9D8B030D-6E8A-4147-A177-3AD203B41FA5}">
                      <a16:colId xmlns:a16="http://schemas.microsoft.com/office/drawing/2014/main" val="2297412863"/>
                    </a:ext>
                  </a:extLst>
                </a:gridCol>
                <a:gridCol w="343200">
                  <a:extLst>
                    <a:ext uri="{9D8B030D-6E8A-4147-A177-3AD203B41FA5}">
                      <a16:colId xmlns:a16="http://schemas.microsoft.com/office/drawing/2014/main" val="1216334408"/>
                    </a:ext>
                  </a:extLst>
                </a:gridCol>
                <a:gridCol w="342500">
                  <a:extLst>
                    <a:ext uri="{9D8B030D-6E8A-4147-A177-3AD203B41FA5}">
                      <a16:colId xmlns:a16="http://schemas.microsoft.com/office/drawing/2014/main" val="3799438353"/>
                    </a:ext>
                  </a:extLst>
                </a:gridCol>
                <a:gridCol w="342500">
                  <a:extLst>
                    <a:ext uri="{9D8B030D-6E8A-4147-A177-3AD203B41FA5}">
                      <a16:colId xmlns:a16="http://schemas.microsoft.com/office/drawing/2014/main" val="1225779857"/>
                    </a:ext>
                  </a:extLst>
                </a:gridCol>
                <a:gridCol w="342500">
                  <a:extLst>
                    <a:ext uri="{9D8B030D-6E8A-4147-A177-3AD203B41FA5}">
                      <a16:colId xmlns:a16="http://schemas.microsoft.com/office/drawing/2014/main" val="4282612222"/>
                    </a:ext>
                  </a:extLst>
                </a:gridCol>
                <a:gridCol w="343200">
                  <a:extLst>
                    <a:ext uri="{9D8B030D-6E8A-4147-A177-3AD203B41FA5}">
                      <a16:colId xmlns:a16="http://schemas.microsoft.com/office/drawing/2014/main" val="3775057744"/>
                    </a:ext>
                  </a:extLst>
                </a:gridCol>
              </a:tblGrid>
              <a:tr h="114352">
                <a:tc gridSpan="12">
                  <a:txBody>
                    <a:bodyPr/>
                    <a:lstStyle/>
                    <a:p>
                      <a:pPr algn="ctr"/>
                      <a:r>
                        <a:rPr lang="en-CH" sz="6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HSCT-MS Patients</a:t>
                      </a:r>
                      <a:endParaRPr lang="en-CH" sz="6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CH" sz="80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 hMerge="1">
                  <a:txBody>
                    <a:bodyPr/>
                    <a:lstStyle/>
                    <a:p>
                      <a:pPr algn="ctr"/>
                      <a:endParaRPr lang="en-CH" sz="80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 hMerge="1">
                  <a:txBody>
                    <a:bodyPr/>
                    <a:lstStyle/>
                    <a:p>
                      <a:pPr algn="ctr"/>
                      <a:endParaRPr lang="en-CH" sz="80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 hMerge="1">
                  <a:txBody>
                    <a:bodyPr/>
                    <a:lstStyle/>
                    <a:p>
                      <a:pPr algn="ctr"/>
                      <a:endParaRPr lang="en-CH" sz="80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 hMerge="1">
                  <a:txBody>
                    <a:bodyPr/>
                    <a:lstStyle/>
                    <a:p>
                      <a:pPr algn="ctr"/>
                      <a:endParaRPr lang="en-CH" sz="80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 hMerge="1">
                  <a:txBody>
                    <a:bodyPr/>
                    <a:lstStyle/>
                    <a:p>
                      <a:pPr algn="ctr"/>
                      <a:endParaRPr lang="en-CH" sz="80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</a:tcPr>
                </a:tc>
                <a:tc hMerge="1">
                  <a:txBody>
                    <a:bodyPr/>
                    <a:lstStyle/>
                    <a:p>
                      <a:endParaRPr lang="en-CH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CH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CH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CH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CH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810882117"/>
                  </a:ext>
                </a:extLst>
              </a:tr>
              <a:tr h="105410">
                <a:tc>
                  <a:txBody>
                    <a:bodyPr/>
                    <a:lstStyle/>
                    <a:p>
                      <a:pPr algn="ctr"/>
                      <a:r>
                        <a:rPr lang="en-US" sz="6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AMPLE ID</a:t>
                      </a:r>
                      <a:endParaRPr lang="en-CH" sz="6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CH" sz="600" b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IAGNOSIS</a:t>
                      </a:r>
                      <a:endParaRPr lang="en-CH" sz="600" b="1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 b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E-</a:t>
                      </a:r>
                      <a:r>
                        <a:rPr lang="en-US" sz="600" b="1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HSCT</a:t>
                      </a:r>
                      <a:r>
                        <a:rPr lang="en-US" sz="600" b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THERAPY</a:t>
                      </a:r>
                      <a:endParaRPr lang="en-CH" sz="600" b="1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 b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EX</a:t>
                      </a:r>
                      <a:endParaRPr lang="en-CH" sz="600" b="1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 b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GE AT </a:t>
                      </a:r>
                      <a:r>
                        <a:rPr lang="en-US" sz="600" b="1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HSCT</a:t>
                      </a:r>
                      <a:endParaRPr lang="en-CH" sz="600" b="1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 b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BV </a:t>
                      </a:r>
                      <a:r>
                        <a:rPr lang="en-US" sz="550" b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ACTIVATION</a:t>
                      </a:r>
                      <a:endParaRPr lang="en-CH" sz="550" b="1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gridSpan="6">
                  <a:txBody>
                    <a:bodyPr/>
                    <a:lstStyle/>
                    <a:p>
                      <a:pPr algn="ctr"/>
                      <a:r>
                        <a:rPr lang="en-US" sz="600" b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erum (S) and/or flow cytometry (F) analyses</a:t>
                      </a:r>
                      <a:endParaRPr lang="en-CH" sz="600" b="1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en-CH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CH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CH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CH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CH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619257579"/>
                  </a:ext>
                </a:extLst>
              </a:tr>
              <a:tr h="105410">
                <a:tc>
                  <a:txBody>
                    <a:bodyPr/>
                    <a:lstStyle/>
                    <a:p>
                      <a:pPr algn="ctr"/>
                      <a:r>
                        <a:rPr lang="en-US" sz="6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CH" sz="6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CH" sz="6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CH" sz="6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CH" sz="6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CH" sz="6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CH" sz="6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 b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e</a:t>
                      </a:r>
                      <a:endParaRPr lang="en-CH" sz="600" b="1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 b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1</a:t>
                      </a:r>
                      <a:endParaRPr lang="en-CH" sz="600" b="1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 b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3</a:t>
                      </a:r>
                      <a:endParaRPr lang="en-CH" sz="600" b="1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 b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6</a:t>
                      </a:r>
                      <a:endParaRPr lang="en-CH" sz="600" b="1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 b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12</a:t>
                      </a:r>
                      <a:endParaRPr lang="en-CH" sz="600" b="1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 b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24</a:t>
                      </a:r>
                      <a:endParaRPr lang="en-CH" sz="600" b="1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57157511"/>
                  </a:ext>
                </a:extLst>
              </a:tr>
              <a:tr h="105410">
                <a:tc>
                  <a:txBody>
                    <a:bodyPr/>
                    <a:lstStyle/>
                    <a:p>
                      <a:pPr algn="ctr"/>
                      <a:r>
                        <a:rPr lang="en-US" sz="6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HSCT1</a:t>
                      </a:r>
                      <a:endParaRPr lang="en-CH" sz="6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CH" sz="6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RMS</a:t>
                      </a:r>
                      <a:endParaRPr lang="en-CH" sz="6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AT</a:t>
                      </a:r>
                      <a:endParaRPr lang="en-CH" sz="6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emale</a:t>
                      </a:r>
                      <a:endParaRPr lang="en-CH" sz="6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8</a:t>
                      </a:r>
                      <a:endParaRPr lang="en-CH" sz="6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endParaRPr lang="en-CH" sz="6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, S</a:t>
                      </a:r>
                      <a:endParaRPr lang="en-CH" sz="6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, (S)</a:t>
                      </a:r>
                      <a:endParaRPr lang="en-CH" sz="6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endParaRPr lang="en-CH" sz="6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</a:t>
                      </a:r>
                      <a:endParaRPr lang="en-CH" sz="6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</a:t>
                      </a:r>
                      <a:endParaRPr lang="en-CH" sz="6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, (S)</a:t>
                      </a:r>
                      <a:endParaRPr lang="en-CH" sz="6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47074633"/>
                  </a:ext>
                </a:extLst>
              </a:tr>
              <a:tr h="105410">
                <a:tc>
                  <a:txBody>
                    <a:bodyPr/>
                    <a:lstStyle/>
                    <a:p>
                      <a:pPr algn="ctr"/>
                      <a:r>
                        <a:rPr lang="en-US" sz="6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HSCT10</a:t>
                      </a:r>
                      <a:endParaRPr lang="en-CH" sz="6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CH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PMS</a:t>
                      </a:r>
                      <a:endParaRPr lang="en-CH" sz="6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CR</a:t>
                      </a:r>
                      <a:endParaRPr lang="en-CH" sz="6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emale</a:t>
                      </a:r>
                      <a:endParaRPr lang="en-CH" sz="6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6</a:t>
                      </a:r>
                      <a:endParaRPr lang="en-CH" sz="6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endParaRPr lang="en-CH" sz="6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, S</a:t>
                      </a:r>
                      <a:endParaRPr lang="en-CH" sz="6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, S</a:t>
                      </a:r>
                      <a:endParaRPr lang="en-CH" sz="6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</a:t>
                      </a:r>
                      <a:endParaRPr lang="en-CH" sz="6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</a:t>
                      </a:r>
                      <a:endParaRPr lang="en-CH" sz="6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</a:t>
                      </a:r>
                      <a:endParaRPr lang="en-CH" sz="6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, S</a:t>
                      </a:r>
                      <a:endParaRPr lang="en-CH" sz="6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9931971"/>
                  </a:ext>
                </a:extLst>
              </a:tr>
              <a:tr h="105410">
                <a:tc>
                  <a:txBody>
                    <a:bodyPr/>
                    <a:lstStyle/>
                    <a:p>
                      <a:pPr algn="ctr"/>
                      <a:r>
                        <a:rPr lang="en-US" sz="6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HSCT11</a:t>
                      </a:r>
                      <a:endParaRPr lang="en-CH" sz="6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CH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RMS</a:t>
                      </a:r>
                      <a:endParaRPr lang="en-CH" sz="6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CR</a:t>
                      </a:r>
                      <a:endParaRPr lang="en-CH" sz="6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ale</a:t>
                      </a:r>
                      <a:endParaRPr lang="en-CH" sz="6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7</a:t>
                      </a:r>
                      <a:endParaRPr lang="en-CH" sz="6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endParaRPr lang="en-CH" sz="6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, S</a:t>
                      </a:r>
                      <a:endParaRPr lang="en-CH" sz="6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, S</a:t>
                      </a:r>
                      <a:endParaRPr lang="en-CH" sz="6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</a:t>
                      </a:r>
                      <a:endParaRPr lang="en-CH" sz="6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</a:t>
                      </a:r>
                      <a:endParaRPr lang="en-CH" sz="6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</a:t>
                      </a:r>
                      <a:endParaRPr lang="en-CH" sz="6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, S</a:t>
                      </a:r>
                      <a:endParaRPr lang="en-CH" sz="6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17395809"/>
                  </a:ext>
                </a:extLst>
              </a:tr>
              <a:tr h="105410"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HSCT13</a:t>
                      </a:r>
                      <a:endParaRPr lang="en-CH" sz="6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CH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PMS</a:t>
                      </a:r>
                      <a:endParaRPr lang="en-CH" sz="6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CR</a:t>
                      </a:r>
                      <a:endParaRPr lang="en-CH" sz="6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ale</a:t>
                      </a:r>
                      <a:endParaRPr lang="en-CH" sz="6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1</a:t>
                      </a:r>
                      <a:endParaRPr lang="en-CH" sz="6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endParaRPr lang="en-CH" sz="6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, S</a:t>
                      </a:r>
                      <a:endParaRPr lang="en-CH" sz="6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, S</a:t>
                      </a:r>
                      <a:endParaRPr lang="en-CH" sz="6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</a:t>
                      </a:r>
                      <a:endParaRPr lang="en-CH" sz="6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</a:t>
                      </a:r>
                      <a:endParaRPr lang="en-CH" sz="6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</a:t>
                      </a:r>
                      <a:endParaRPr lang="en-CH" sz="6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, (S)</a:t>
                      </a:r>
                      <a:endParaRPr lang="en-CH" sz="6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00144253"/>
                  </a:ext>
                </a:extLst>
              </a:tr>
              <a:tr h="105410"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HSCT16</a:t>
                      </a:r>
                      <a:endParaRPr lang="en-CH" sz="6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CH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RMS</a:t>
                      </a:r>
                      <a:endParaRPr lang="en-CH" sz="6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CR</a:t>
                      </a:r>
                      <a:endParaRPr lang="en-CH" sz="6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emale</a:t>
                      </a:r>
                      <a:endParaRPr lang="en-CH" sz="6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3</a:t>
                      </a:r>
                      <a:endParaRPr lang="en-CH" sz="6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endParaRPr lang="en-CH" sz="6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, S</a:t>
                      </a:r>
                      <a:endParaRPr lang="en-CH" sz="6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, S</a:t>
                      </a:r>
                      <a:endParaRPr lang="en-CH" sz="6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</a:t>
                      </a:r>
                      <a:endParaRPr lang="en-CH" sz="6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</a:t>
                      </a:r>
                      <a:endParaRPr lang="en-CH" sz="6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</a:t>
                      </a:r>
                      <a:endParaRPr lang="en-CH" sz="6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</a:t>
                      </a:r>
                      <a:endParaRPr lang="en-CH" sz="6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81958517"/>
                  </a:ext>
                </a:extLst>
              </a:tr>
              <a:tr h="105410">
                <a:tc>
                  <a:txBody>
                    <a:bodyPr/>
                    <a:lstStyle/>
                    <a:p>
                      <a:pPr algn="ctr"/>
                      <a:r>
                        <a:rPr lang="en-US" sz="6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HSCT20</a:t>
                      </a:r>
                      <a:endParaRPr lang="en-CH" sz="6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CH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PMS</a:t>
                      </a:r>
                      <a:endParaRPr lang="en-CH" sz="6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CR</a:t>
                      </a:r>
                      <a:endParaRPr lang="en-CH" sz="6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ale</a:t>
                      </a:r>
                      <a:endParaRPr lang="en-CH" sz="6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7</a:t>
                      </a:r>
                      <a:endParaRPr lang="en-CH" sz="6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endParaRPr lang="en-CH" sz="6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, S</a:t>
                      </a:r>
                      <a:endParaRPr lang="en-CH" sz="6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, S</a:t>
                      </a:r>
                      <a:endParaRPr lang="en-CH" sz="6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</a:t>
                      </a:r>
                      <a:endParaRPr lang="en-CH" sz="6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</a:t>
                      </a:r>
                      <a:endParaRPr lang="en-CH" sz="6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</a:t>
                      </a:r>
                      <a:endParaRPr lang="en-CH" sz="6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</a:t>
                      </a:r>
                      <a:endParaRPr lang="en-CH" sz="6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10511427"/>
                  </a:ext>
                </a:extLst>
              </a:tr>
              <a:tr h="105410">
                <a:tc>
                  <a:txBody>
                    <a:bodyPr/>
                    <a:lstStyle/>
                    <a:p>
                      <a:pPr algn="ctr"/>
                      <a:r>
                        <a:rPr lang="en-US" sz="6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HSCT31</a:t>
                      </a:r>
                      <a:endParaRPr lang="en-CH" sz="6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CH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RMS</a:t>
                      </a:r>
                      <a:endParaRPr lang="en-CH" sz="6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CR</a:t>
                      </a:r>
                      <a:endParaRPr lang="en-CH" sz="6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emale</a:t>
                      </a:r>
                      <a:endParaRPr lang="en-CH" sz="6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9</a:t>
                      </a:r>
                      <a:endParaRPr lang="en-CH" sz="6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endParaRPr lang="en-CH" sz="6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</a:t>
                      </a:r>
                      <a:endParaRPr lang="en-CH" sz="6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</a:t>
                      </a:r>
                      <a:endParaRPr lang="en-CH" sz="6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endParaRPr lang="en-CH" sz="6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endParaRPr lang="en-CH" sz="6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</a:t>
                      </a:r>
                      <a:endParaRPr lang="en-CH" sz="6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endParaRPr lang="en-CH" sz="6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08949032"/>
                  </a:ext>
                </a:extLst>
              </a:tr>
              <a:tr h="105410"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HSCT17</a:t>
                      </a:r>
                      <a:endParaRPr lang="en-CH" sz="6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CH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RMS</a:t>
                      </a:r>
                      <a:endParaRPr lang="en-CH" sz="6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CR</a:t>
                      </a:r>
                      <a:endParaRPr lang="en-CH" sz="6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emale</a:t>
                      </a:r>
                      <a:endParaRPr lang="en-CH" sz="6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9</a:t>
                      </a:r>
                      <a:endParaRPr lang="en-CH" sz="6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</a:t>
                      </a:r>
                      <a:endParaRPr lang="en-CH" sz="6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, S</a:t>
                      </a:r>
                      <a:endParaRPr lang="en-CH" sz="6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, S</a:t>
                      </a:r>
                      <a:endParaRPr lang="en-CH" sz="6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</a:t>
                      </a:r>
                      <a:endParaRPr lang="en-CH" sz="6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</a:t>
                      </a:r>
                      <a:endParaRPr lang="en-CH" sz="6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</a:t>
                      </a:r>
                      <a:endParaRPr lang="en-CH" sz="6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</a:t>
                      </a:r>
                      <a:endParaRPr lang="en-CH" sz="6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09826397"/>
                  </a:ext>
                </a:extLst>
              </a:tr>
              <a:tr h="105410"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HSCT18</a:t>
                      </a:r>
                      <a:endParaRPr lang="en-CH" sz="6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CH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RMS</a:t>
                      </a:r>
                      <a:endParaRPr lang="en-CH" sz="6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AT</a:t>
                      </a:r>
                      <a:endParaRPr lang="en-CH" sz="6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ale</a:t>
                      </a:r>
                      <a:endParaRPr lang="en-CH" sz="6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7</a:t>
                      </a:r>
                      <a:endParaRPr lang="en-CH" sz="6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</a:t>
                      </a:r>
                      <a:endParaRPr lang="en-CH" sz="6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, S</a:t>
                      </a:r>
                      <a:endParaRPr lang="en-CH" sz="6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, S</a:t>
                      </a:r>
                      <a:endParaRPr lang="en-CH" sz="6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</a:t>
                      </a:r>
                      <a:endParaRPr lang="en-CH" sz="6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</a:t>
                      </a:r>
                      <a:endParaRPr lang="en-CH" sz="6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</a:t>
                      </a:r>
                      <a:endParaRPr lang="en-CH" sz="6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</a:t>
                      </a:r>
                      <a:endParaRPr lang="en-CH" sz="6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47028140"/>
                  </a:ext>
                </a:extLst>
              </a:tr>
              <a:tr h="105410">
                <a:tc>
                  <a:txBody>
                    <a:bodyPr/>
                    <a:lstStyle/>
                    <a:p>
                      <a:pPr algn="ctr"/>
                      <a:r>
                        <a:rPr lang="en-US" sz="6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HSCT21</a:t>
                      </a:r>
                      <a:endParaRPr lang="en-CH" sz="6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CH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RMS</a:t>
                      </a:r>
                      <a:endParaRPr lang="en-CH" sz="6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CR</a:t>
                      </a:r>
                      <a:endParaRPr lang="en-CH" sz="6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ale</a:t>
                      </a:r>
                      <a:endParaRPr lang="en-CH" sz="6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5</a:t>
                      </a:r>
                      <a:endParaRPr lang="en-CH" sz="6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</a:t>
                      </a:r>
                      <a:endParaRPr lang="en-CH" sz="6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, S</a:t>
                      </a:r>
                      <a:endParaRPr lang="en-CH" sz="6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, S</a:t>
                      </a:r>
                      <a:endParaRPr lang="en-CH" sz="6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</a:t>
                      </a:r>
                      <a:endParaRPr lang="en-CH" sz="6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</a:t>
                      </a:r>
                      <a:endParaRPr lang="en-CH" sz="6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</a:t>
                      </a:r>
                      <a:endParaRPr lang="en-CH" sz="6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</a:t>
                      </a:r>
                      <a:endParaRPr lang="en-CH" sz="6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23716082"/>
                  </a:ext>
                </a:extLst>
              </a:tr>
              <a:tr h="105410">
                <a:tc>
                  <a:txBody>
                    <a:bodyPr/>
                    <a:lstStyle/>
                    <a:p>
                      <a:pPr algn="ctr"/>
                      <a:r>
                        <a:rPr lang="en-US" sz="6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HSCT26</a:t>
                      </a:r>
                      <a:endParaRPr lang="en-CH" sz="6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CH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RMS</a:t>
                      </a:r>
                      <a:endParaRPr lang="en-CH" sz="6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AT</a:t>
                      </a:r>
                      <a:endParaRPr lang="en-CH" sz="6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emale</a:t>
                      </a:r>
                      <a:endParaRPr lang="en-CH" sz="6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0</a:t>
                      </a:r>
                      <a:endParaRPr lang="en-CH" sz="6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</a:t>
                      </a:r>
                      <a:endParaRPr lang="en-CH" sz="6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, S</a:t>
                      </a:r>
                      <a:endParaRPr lang="en-CH" sz="6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, S</a:t>
                      </a:r>
                      <a:endParaRPr lang="en-CH" sz="6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</a:t>
                      </a:r>
                      <a:endParaRPr lang="en-CH" sz="6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</a:t>
                      </a:r>
                      <a:endParaRPr lang="en-CH" sz="6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</a:t>
                      </a:r>
                      <a:endParaRPr lang="en-CH" sz="6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</a:t>
                      </a:r>
                      <a:endParaRPr lang="en-CH" sz="6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24708677"/>
                  </a:ext>
                </a:extLst>
              </a:tr>
              <a:tr h="105410"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HSCT23</a:t>
                      </a:r>
                      <a:endParaRPr lang="en-CH" sz="6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CH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RMS</a:t>
                      </a:r>
                      <a:endParaRPr lang="en-CH" sz="6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AT</a:t>
                      </a:r>
                      <a:endParaRPr lang="en-CH" sz="6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ale</a:t>
                      </a:r>
                      <a:endParaRPr lang="en-CH" sz="6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3</a:t>
                      </a:r>
                      <a:endParaRPr lang="en-CH" sz="6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</a:t>
                      </a:r>
                      <a:endParaRPr lang="en-CH" sz="6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, S</a:t>
                      </a:r>
                      <a:endParaRPr lang="en-CH" sz="6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, S</a:t>
                      </a:r>
                      <a:endParaRPr lang="en-CH" sz="6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</a:t>
                      </a:r>
                      <a:endParaRPr lang="en-CH" sz="6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</a:t>
                      </a:r>
                      <a:endParaRPr lang="en-CH" sz="6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</a:t>
                      </a:r>
                      <a:endParaRPr lang="en-CH" sz="6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</a:t>
                      </a:r>
                      <a:endParaRPr lang="en-CH" sz="6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92021132"/>
                  </a:ext>
                </a:extLst>
              </a:tr>
              <a:tr h="105410">
                <a:tc>
                  <a:txBody>
                    <a:bodyPr/>
                    <a:lstStyle/>
                    <a:p>
                      <a:pPr algn="ctr"/>
                      <a:r>
                        <a:rPr lang="en-US" sz="6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HSCT25</a:t>
                      </a:r>
                      <a:endParaRPr lang="en-CH" sz="6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CH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PMS</a:t>
                      </a:r>
                      <a:endParaRPr lang="en-CH" sz="6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CR</a:t>
                      </a:r>
                      <a:endParaRPr lang="en-CH" sz="6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ale</a:t>
                      </a:r>
                      <a:endParaRPr lang="en-CH" sz="6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4</a:t>
                      </a:r>
                      <a:endParaRPr lang="en-CH" sz="6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</a:t>
                      </a:r>
                      <a:endParaRPr lang="en-CH" sz="6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, S</a:t>
                      </a:r>
                      <a:endParaRPr lang="en-CH" sz="6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, S</a:t>
                      </a:r>
                      <a:endParaRPr lang="en-CH" sz="6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</a:t>
                      </a:r>
                      <a:endParaRPr lang="en-CH" sz="6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</a:t>
                      </a:r>
                      <a:endParaRPr lang="en-CH" sz="6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, S</a:t>
                      </a:r>
                      <a:endParaRPr lang="en-CH" sz="6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endParaRPr lang="en-CH" sz="6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55871203"/>
                  </a:ext>
                </a:extLst>
              </a:tr>
              <a:tr h="84455"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HSCT28</a:t>
                      </a:r>
                      <a:endParaRPr lang="en-CH" sz="6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CH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RMS</a:t>
                      </a:r>
                      <a:endParaRPr lang="en-CH" sz="6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CR</a:t>
                      </a:r>
                      <a:endParaRPr lang="en-CH" sz="6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emale</a:t>
                      </a:r>
                      <a:endParaRPr lang="en-CH" sz="6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2</a:t>
                      </a:r>
                      <a:endParaRPr lang="en-CH" sz="6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</a:t>
                      </a:r>
                      <a:endParaRPr lang="en-CH" sz="6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</a:t>
                      </a:r>
                      <a:endParaRPr lang="en-CH" sz="6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</a:t>
                      </a:r>
                      <a:endParaRPr lang="en-CH" sz="6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endParaRPr lang="en-CH" sz="6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endParaRPr lang="en-CH" sz="6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</a:t>
                      </a:r>
                      <a:endParaRPr lang="en-CH" sz="6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endParaRPr lang="en-CH" sz="6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84209265"/>
                  </a:ext>
                </a:extLst>
              </a:tr>
              <a:tr h="105410"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HSCT32</a:t>
                      </a:r>
                      <a:endParaRPr lang="en-CH" sz="6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CH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RMS</a:t>
                      </a:r>
                      <a:endParaRPr lang="en-CH" sz="6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CR</a:t>
                      </a:r>
                      <a:endParaRPr lang="en-CH" sz="6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ale</a:t>
                      </a:r>
                      <a:endParaRPr lang="en-CH" sz="6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5</a:t>
                      </a:r>
                      <a:endParaRPr lang="en-CH" sz="6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</a:t>
                      </a:r>
                      <a:endParaRPr lang="en-CH" sz="6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</a:t>
                      </a:r>
                      <a:endParaRPr lang="en-CH" sz="6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</a:t>
                      </a:r>
                      <a:endParaRPr lang="en-CH" sz="6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endParaRPr lang="en-CH" sz="6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endParaRPr lang="en-CH" sz="6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</a:t>
                      </a:r>
                      <a:endParaRPr lang="en-CH" sz="6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endParaRPr lang="en-CH" sz="6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28457691"/>
                  </a:ext>
                </a:extLst>
              </a:tr>
              <a:tr h="105410">
                <a:tc>
                  <a:txBody>
                    <a:bodyPr/>
                    <a:lstStyle/>
                    <a:p>
                      <a:pPr algn="ctr"/>
                      <a:r>
                        <a:rPr lang="en-US" sz="6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ummary</a:t>
                      </a:r>
                      <a:endParaRPr lang="en-CH" sz="6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/>
                      <a:r>
                        <a:rPr lang="en-US" sz="6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n = 15)</a:t>
                      </a:r>
                      <a:endParaRPr lang="en-CH" sz="6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x RRMS 2x SPMS</a:t>
                      </a:r>
                      <a:endParaRPr lang="en-CH" sz="6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/>
                      <a:r>
                        <a:rPr lang="en-US" sz="6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x PPMS</a:t>
                      </a:r>
                      <a:endParaRPr lang="en-CH" sz="6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x NAT</a:t>
                      </a:r>
                      <a:endParaRPr lang="en-CH" sz="6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/>
                      <a:r>
                        <a:rPr lang="en-US" sz="6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x OCR</a:t>
                      </a:r>
                      <a:endParaRPr lang="en-CH" sz="6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x female</a:t>
                      </a:r>
                      <a:endParaRPr lang="en-CH" sz="60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/>
                      <a:r>
                        <a:rPr lang="en-US" sz="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x male</a:t>
                      </a:r>
                      <a:endParaRPr lang="en-CH" sz="6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9</a:t>
                      </a:r>
                      <a:endParaRPr lang="en-CH" sz="6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x reactivation</a:t>
                      </a:r>
                      <a:endParaRPr lang="en-CH" sz="6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/>
                      <a:r>
                        <a:rPr lang="en-US" sz="6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x no reactivation</a:t>
                      </a:r>
                      <a:endParaRPr lang="en-CH" sz="6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CH" sz="6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2xF</a:t>
                      </a:r>
                      <a:endParaRPr lang="en-CH" sz="6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/>
                      <a:r>
                        <a:rPr lang="it-CH" sz="6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5xS</a:t>
                      </a:r>
                      <a:endParaRPr lang="en-CH" sz="6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CH" sz="6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2xF</a:t>
                      </a:r>
                      <a:endParaRPr lang="en-CH" sz="6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/>
                      <a:r>
                        <a:rPr lang="it-CH" sz="6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5xS</a:t>
                      </a:r>
                      <a:endParaRPr lang="en-CH" sz="6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CH" sz="6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xF</a:t>
                      </a:r>
                      <a:endParaRPr lang="en-CH" sz="6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/>
                      <a:r>
                        <a:rPr lang="it-CH" sz="6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xS</a:t>
                      </a:r>
                      <a:endParaRPr lang="en-CH" sz="6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CH" sz="6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2xF</a:t>
                      </a:r>
                      <a:endParaRPr lang="en-CH" sz="6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/>
                      <a:r>
                        <a:rPr lang="it-CH" sz="6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xS</a:t>
                      </a:r>
                      <a:endParaRPr lang="en-CH" sz="6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CH" sz="6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2xF</a:t>
                      </a:r>
                      <a:endParaRPr lang="en-CH" sz="6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/>
                      <a:r>
                        <a:rPr lang="it-CH" sz="6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xS</a:t>
                      </a:r>
                      <a:endParaRPr lang="en-CH" sz="6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CH" sz="6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xF</a:t>
                      </a:r>
                      <a:endParaRPr lang="en-CH" sz="6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/>
                      <a:r>
                        <a:rPr lang="it-CH" sz="6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xS</a:t>
                      </a:r>
                      <a:endParaRPr lang="en-CH" sz="6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70382408"/>
                  </a:ext>
                </a:extLst>
              </a:tr>
            </a:tbl>
          </a:graphicData>
        </a:graphic>
      </p:graphicFrame>
      <p:sp>
        <p:nvSpPr>
          <p:cNvPr id="8" name="TextBox 7">
            <a:extLst>
              <a:ext uri="{FF2B5EF4-FFF2-40B4-BE49-F238E27FC236}">
                <a16:creationId xmlns:a16="http://schemas.microsoft.com/office/drawing/2014/main" id="{D654C5B1-4721-03EA-5396-391450330CD6}"/>
              </a:ext>
            </a:extLst>
          </p:cNvPr>
          <p:cNvSpPr txBox="1"/>
          <p:nvPr/>
        </p:nvSpPr>
        <p:spPr>
          <a:xfrm>
            <a:off x="423746" y="8445460"/>
            <a:ext cx="5999355" cy="1169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0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Table 1</a:t>
            </a:r>
            <a:r>
              <a:rPr lang="en-GB" sz="1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: Demographics of all donors. Individuals highlighted in red were excluded from analysis due to the low viability of lymphocytes after stimulation </a:t>
            </a:r>
            <a:r>
              <a:rPr lang="en-GB" sz="10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in vitro</a:t>
            </a:r>
            <a:r>
              <a:rPr lang="en-GB" sz="1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(≤60%). They were also excluded in the summary calculations at the bottom of each table section. HD = Healthy Donors, RRMS = Relapsing-Remitting Multiple Sclerosis, </a:t>
            </a:r>
            <a:r>
              <a:rPr lang="en-GB" sz="10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HSCT</a:t>
            </a:r>
            <a:r>
              <a:rPr lang="en-GB" sz="1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= autologous Hematopoietic Stem Cell Transplantation, NAT = Natalizumab, OCR = Ocrelizumab, EDSS = Expanded Disability Status Scale, M = Month post </a:t>
            </a:r>
            <a:r>
              <a:rPr lang="en-GB" sz="10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HSCT</a:t>
            </a:r>
            <a:r>
              <a:rPr lang="en-GB" sz="1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 The label “(S)” indicates that sample volumes were insufficient for the quantification of total IgG and therefore only used for detection of anti-EBNA1 IgG. </a:t>
            </a:r>
            <a:endParaRPr lang="en-CH" sz="1000" dirty="0"/>
          </a:p>
        </p:txBody>
      </p:sp>
    </p:spTree>
    <p:extLst>
      <p:ext uri="{BB962C8B-B14F-4D97-AF65-F5344CB8AC3E}">
        <p14:creationId xmlns:p14="http://schemas.microsoft.com/office/powerpoint/2010/main" val="269535159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 descr="Diagram&#10;&#10;Description automatically generated">
            <a:extLst>
              <a:ext uri="{FF2B5EF4-FFF2-40B4-BE49-F238E27FC236}">
                <a16:creationId xmlns:a16="http://schemas.microsoft.com/office/drawing/2014/main" id="{48185955-F248-29BB-48D0-F40F938B2FEC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21682"/>
          <a:stretch/>
        </p:blipFill>
        <p:spPr bwMode="auto">
          <a:xfrm>
            <a:off x="3774882" y="3610435"/>
            <a:ext cx="2445385" cy="2477770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pic>
        <p:nvPicPr>
          <p:cNvPr id="7" name="Picture 6" descr="Diagram, engineering drawing&#10;&#10;Description automatically generated">
            <a:extLst>
              <a:ext uri="{FF2B5EF4-FFF2-40B4-BE49-F238E27FC236}">
                <a16:creationId xmlns:a16="http://schemas.microsoft.com/office/drawing/2014/main" id="{4693824F-B904-57F8-68B0-7E4A23A50CF1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228"/>
          <a:stretch/>
        </p:blipFill>
        <p:spPr bwMode="auto">
          <a:xfrm>
            <a:off x="603603" y="591198"/>
            <a:ext cx="2798445" cy="2705100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FABE7A6D-D1E1-D162-7393-5AF2D055AD98}"/>
              </a:ext>
            </a:extLst>
          </p:cNvPr>
          <p:cNvSpPr txBox="1"/>
          <p:nvPr/>
        </p:nvSpPr>
        <p:spPr>
          <a:xfrm>
            <a:off x="508053" y="323400"/>
            <a:ext cx="28725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H" sz="11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6655AAEC-2785-2574-D0DC-5FFB72C97289}"/>
              </a:ext>
            </a:extLst>
          </p:cNvPr>
          <p:cNvSpPr txBox="1"/>
          <p:nvPr/>
        </p:nvSpPr>
        <p:spPr>
          <a:xfrm>
            <a:off x="3544986" y="323400"/>
            <a:ext cx="28725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H" sz="11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pic>
        <p:nvPicPr>
          <p:cNvPr id="10" name="Picture 9" descr="Diagram&#10;&#10;Description automatically generated">
            <a:extLst>
              <a:ext uri="{FF2B5EF4-FFF2-40B4-BE49-F238E27FC236}">
                <a16:creationId xmlns:a16="http://schemas.microsoft.com/office/drawing/2014/main" id="{2103CC06-DEA1-796C-1E98-8BA92351644B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9630" y="591109"/>
            <a:ext cx="2675890" cy="2705100"/>
          </a:xfrm>
          <a:prstGeom prst="rect">
            <a:avLst/>
          </a:prstGeom>
        </p:spPr>
      </p:pic>
      <p:pic>
        <p:nvPicPr>
          <p:cNvPr id="11" name="Picture 10" descr="Diagram&#10;&#10;Description automatically generated">
            <a:extLst>
              <a:ext uri="{FF2B5EF4-FFF2-40B4-BE49-F238E27FC236}">
                <a16:creationId xmlns:a16="http://schemas.microsoft.com/office/drawing/2014/main" id="{57A8540A-98AB-3D40-FDFE-22F23CAF7469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62" t="3947"/>
          <a:stretch/>
        </p:blipFill>
        <p:spPr bwMode="auto">
          <a:xfrm>
            <a:off x="603602" y="3640828"/>
            <a:ext cx="2798445" cy="2722880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sp>
        <p:nvSpPr>
          <p:cNvPr id="12" name="TextBox 11">
            <a:extLst>
              <a:ext uri="{FF2B5EF4-FFF2-40B4-BE49-F238E27FC236}">
                <a16:creationId xmlns:a16="http://schemas.microsoft.com/office/drawing/2014/main" id="{FA92C5A4-598D-FC20-BC3B-D0C3815B54E2}"/>
              </a:ext>
            </a:extLst>
          </p:cNvPr>
          <p:cNvSpPr txBox="1"/>
          <p:nvPr/>
        </p:nvSpPr>
        <p:spPr>
          <a:xfrm>
            <a:off x="515266" y="3372396"/>
            <a:ext cx="28725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H" sz="11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01776B2F-7BF7-9A71-FFF1-A32D5926BC74}"/>
              </a:ext>
            </a:extLst>
          </p:cNvPr>
          <p:cNvSpPr txBox="1"/>
          <p:nvPr/>
        </p:nvSpPr>
        <p:spPr>
          <a:xfrm>
            <a:off x="3516364" y="3372396"/>
            <a:ext cx="28725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H" sz="11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14" name="Rectangle 13">
            <a:extLst>
              <a:ext uri="{FF2B5EF4-FFF2-40B4-BE49-F238E27FC236}">
                <a16:creationId xmlns:a16="http://schemas.microsoft.com/office/drawing/2014/main" id="{53498240-14AB-727C-D475-9BB56DB366D2}"/>
              </a:ext>
            </a:extLst>
          </p:cNvPr>
          <p:cNvSpPr/>
          <p:nvPr/>
        </p:nvSpPr>
        <p:spPr>
          <a:xfrm>
            <a:off x="4254293" y="3705931"/>
            <a:ext cx="1965325" cy="1958975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endParaRPr lang="en-GB"/>
          </a:p>
        </p:txBody>
      </p:sp>
      <p:sp>
        <p:nvSpPr>
          <p:cNvPr id="15" name="Rectangle 14">
            <a:extLst>
              <a:ext uri="{FF2B5EF4-FFF2-40B4-BE49-F238E27FC236}">
                <a16:creationId xmlns:a16="http://schemas.microsoft.com/office/drawing/2014/main" id="{4181DF99-F379-1D8A-C3EB-657E6B878F7E}"/>
              </a:ext>
            </a:extLst>
          </p:cNvPr>
          <p:cNvSpPr/>
          <p:nvPr/>
        </p:nvSpPr>
        <p:spPr>
          <a:xfrm>
            <a:off x="617020" y="4330265"/>
            <a:ext cx="700939" cy="691508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endParaRPr lang="en-GB"/>
          </a:p>
        </p:txBody>
      </p:sp>
      <p:sp>
        <p:nvSpPr>
          <p:cNvPr id="16" name="Rectangle 15">
            <a:extLst>
              <a:ext uri="{FF2B5EF4-FFF2-40B4-BE49-F238E27FC236}">
                <a16:creationId xmlns:a16="http://schemas.microsoft.com/office/drawing/2014/main" id="{2DB3FFF2-2FBA-307B-9F36-D82AB6ED9348}"/>
              </a:ext>
            </a:extLst>
          </p:cNvPr>
          <p:cNvSpPr/>
          <p:nvPr/>
        </p:nvSpPr>
        <p:spPr>
          <a:xfrm>
            <a:off x="1317959" y="5021772"/>
            <a:ext cx="693580" cy="673211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endParaRPr lang="en-GB"/>
          </a:p>
        </p:txBody>
      </p:sp>
      <p:sp>
        <p:nvSpPr>
          <p:cNvPr id="17" name="Rectangle 16">
            <a:extLst>
              <a:ext uri="{FF2B5EF4-FFF2-40B4-BE49-F238E27FC236}">
                <a16:creationId xmlns:a16="http://schemas.microsoft.com/office/drawing/2014/main" id="{8C116FA6-02A4-EC33-11EB-CA6BF6891B45}"/>
              </a:ext>
            </a:extLst>
          </p:cNvPr>
          <p:cNvSpPr/>
          <p:nvPr/>
        </p:nvSpPr>
        <p:spPr>
          <a:xfrm>
            <a:off x="2010196" y="5688968"/>
            <a:ext cx="700939" cy="673211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endParaRPr lang="en-GB"/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C6A2D799-CCE5-C2CB-93A5-C1791B50102A}"/>
              </a:ext>
            </a:extLst>
          </p:cNvPr>
          <p:cNvSpPr txBox="1"/>
          <p:nvPr/>
        </p:nvSpPr>
        <p:spPr>
          <a:xfrm>
            <a:off x="488313" y="6370530"/>
            <a:ext cx="5827467" cy="9659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15000"/>
              </a:lnSpc>
              <a:spcBef>
                <a:spcPts val="400"/>
              </a:spcBef>
              <a:spcAft>
                <a:spcPts val="400"/>
              </a:spcAft>
            </a:pPr>
            <a:r>
              <a:rPr lang="en-GB" sz="10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1</a:t>
            </a:r>
            <a:r>
              <a:rPr lang="en-GB" sz="1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: Representative flow cytometry gating strategy for </a:t>
            </a:r>
            <a:r>
              <a:rPr lang="en-GB" sz="10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tainings</a:t>
            </a:r>
            <a:r>
              <a:rPr lang="en-GB" sz="1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on day 0 (A), on day 7 after stimulation (B), and on day 7 without stimulation (C). (D) The general solution for gating multiple panels comparing CD24 and CD38 using exemplary dat</a:t>
            </a:r>
            <a:r>
              <a:rPr lang="en-GB" sz="1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 from a </a:t>
            </a:r>
            <a:r>
              <a:rPr lang="en-GB" sz="1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non-stimulated sample. The panels were shaped in a way to minimize overlapping. All figures are based on data from donor HD6. SM = switched memory, USM = unswitched memory, SP = Single positive, DP = Double positive, DN = Double negative.</a:t>
            </a:r>
            <a:endParaRPr lang="en-CH" sz="1000" dirty="0">
              <a:effectLst/>
              <a:latin typeface="centur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6516181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Picture 8" descr="Chart, box and whisker chart&#10;&#10;Description automatically generated">
            <a:extLst>
              <a:ext uri="{FF2B5EF4-FFF2-40B4-BE49-F238E27FC236}">
                <a16:creationId xmlns:a16="http://schemas.microsoft.com/office/drawing/2014/main" id="{0E0FA8EC-FFE6-4497-9513-3C2559A2D79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279650" y="311263"/>
            <a:ext cx="2298700" cy="2043430"/>
          </a:xfrm>
          <a:prstGeom prst="rect">
            <a:avLst/>
          </a:prstGeom>
        </p:spPr>
      </p:pic>
      <p:sp>
        <p:nvSpPr>
          <p:cNvPr id="14" name="TextBox 13">
            <a:extLst>
              <a:ext uri="{FF2B5EF4-FFF2-40B4-BE49-F238E27FC236}">
                <a16:creationId xmlns:a16="http://schemas.microsoft.com/office/drawing/2014/main" id="{6992CE52-DBA8-836F-C20F-951E3B48C9AB}"/>
              </a:ext>
            </a:extLst>
          </p:cNvPr>
          <p:cNvSpPr txBox="1"/>
          <p:nvPr/>
        </p:nvSpPr>
        <p:spPr>
          <a:xfrm>
            <a:off x="565149" y="2445712"/>
            <a:ext cx="5895473" cy="61202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15000"/>
              </a:lnSpc>
              <a:spcBef>
                <a:spcPts val="400"/>
              </a:spcBef>
              <a:spcAft>
                <a:spcPts val="400"/>
              </a:spcAft>
            </a:pPr>
            <a:r>
              <a:rPr lang="en-GB" sz="10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2</a:t>
            </a:r>
            <a:r>
              <a:rPr lang="en-GB" sz="1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: Exclusion criteria for PBMC samples. Donors with a lymphocyte viability of ≤60% (dotted line) after stimulation with IL-2 and R848 (Day 7 +) were excluded from further analyses. This included healthy donors 15 and 18, untreated RRMS patient 17 and NAT patients 1 and 9 as indicated in red.</a:t>
            </a:r>
            <a:endParaRPr lang="en-CH" sz="1000" dirty="0">
              <a:effectLst/>
              <a:latin typeface="centur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0CBA56DF-D32F-F25F-3FDF-D1BB1A93D070}"/>
              </a:ext>
            </a:extLst>
          </p:cNvPr>
          <p:cNvSpPr txBox="1"/>
          <p:nvPr/>
        </p:nvSpPr>
        <p:spPr>
          <a:xfrm>
            <a:off x="584888" y="5988162"/>
            <a:ext cx="5895474" cy="96597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15000"/>
              </a:lnSpc>
              <a:spcBef>
                <a:spcPts val="400"/>
              </a:spcBef>
              <a:spcAft>
                <a:spcPts val="400"/>
              </a:spcAft>
            </a:pPr>
            <a:r>
              <a:rPr lang="en-GB" sz="10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3</a:t>
            </a:r>
            <a:r>
              <a:rPr lang="en-GB" sz="1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: Stimulated B cells mainly consist of class-switched </a:t>
            </a:r>
            <a:r>
              <a:rPr lang="en-GB" sz="10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lasmablasts</a:t>
            </a:r>
            <a:r>
              <a:rPr lang="en-GB" sz="1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 (A) The percentage of CD27</a:t>
            </a:r>
            <a:r>
              <a:rPr lang="en-GB" sz="10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+</a:t>
            </a:r>
            <a:r>
              <a:rPr lang="en-GB" sz="1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10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lasmablasts</a:t>
            </a:r>
            <a:r>
              <a:rPr lang="en-GB" sz="1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(CD138</a:t>
            </a:r>
            <a:r>
              <a:rPr lang="en-GB" sz="10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–</a:t>
            </a:r>
            <a:r>
              <a:rPr lang="en-GB" sz="1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 and plasma cells (CD138</a:t>
            </a:r>
            <a:r>
              <a:rPr lang="en-GB" sz="10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+</a:t>
            </a:r>
            <a:r>
              <a:rPr lang="en-GB" sz="1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 before and after incubation with IL-2 and R848. (B) The contribution of switched (IgM</a:t>
            </a:r>
            <a:r>
              <a:rPr lang="en-GB" sz="10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–</a:t>
            </a:r>
            <a:r>
              <a:rPr lang="en-GB" sz="10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IgD</a:t>
            </a:r>
            <a:r>
              <a:rPr lang="en-GB" sz="10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–</a:t>
            </a:r>
            <a:r>
              <a:rPr lang="en-GB" sz="1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 and unswitched (IgM/</a:t>
            </a:r>
            <a:r>
              <a:rPr lang="en-GB" sz="10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IgD</a:t>
            </a:r>
            <a:r>
              <a:rPr lang="en-GB" sz="1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single- or double-positive) </a:t>
            </a:r>
            <a:r>
              <a:rPr lang="en-GB" sz="10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lasmablasts</a:t>
            </a:r>
            <a:r>
              <a:rPr lang="en-GB" sz="1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and plasma cells. The figures comprise data from all three cohorts (n = 45). p = Wilcoxon signed-rank tests with Holm’s correction. </a:t>
            </a:r>
            <a:endParaRPr lang="en-CH" sz="1000" dirty="0">
              <a:effectLst/>
              <a:latin typeface="centur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4E3A1D8E-6D42-9F6E-F0EB-49FDCB8FCC6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65149" y="3917838"/>
            <a:ext cx="5915211" cy="207032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39292725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TextBox 11">
            <a:extLst>
              <a:ext uri="{FF2B5EF4-FFF2-40B4-BE49-F238E27FC236}">
                <a16:creationId xmlns:a16="http://schemas.microsoft.com/office/drawing/2014/main" id="{FA7F3A6C-8631-A0F0-9C50-01934A09F7B2}"/>
              </a:ext>
            </a:extLst>
          </p:cNvPr>
          <p:cNvSpPr txBox="1"/>
          <p:nvPr/>
        </p:nvSpPr>
        <p:spPr>
          <a:xfrm>
            <a:off x="471394" y="2308760"/>
            <a:ext cx="5915211" cy="61202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15000"/>
              </a:lnSpc>
              <a:spcBef>
                <a:spcPts val="400"/>
              </a:spcBef>
              <a:spcAft>
                <a:spcPts val="400"/>
              </a:spcAft>
            </a:pPr>
            <a:r>
              <a:rPr lang="en-GB" sz="10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</a:t>
            </a:r>
            <a:r>
              <a:rPr lang="en-GB" sz="10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4</a:t>
            </a:r>
            <a:r>
              <a:rPr lang="en-GB" sz="1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: </a:t>
            </a:r>
            <a:r>
              <a:rPr lang="en-GB" sz="1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Upregulation of HLA-DR and downregulation of CD27 on CD3+ T cells in response to stimulation with IL-2 and R848. (A-B) The percentages of T cells expressing HLA-DR (A) and (B) CD27, respectively. p = </a:t>
            </a:r>
            <a:r>
              <a:rPr lang="en-GB" sz="1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Wilcoxon signed-rank tests</a:t>
            </a:r>
            <a:r>
              <a:rPr lang="en-GB" sz="1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with </a:t>
            </a:r>
            <a:r>
              <a:rPr lang="en-GB" sz="1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Holm’s correction</a:t>
            </a:r>
            <a:r>
              <a:rPr lang="en-GB" sz="1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</a:t>
            </a:r>
            <a:endParaRPr lang="en-CH" sz="1000" dirty="0">
              <a:effectLst/>
              <a:latin typeface="centur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AE4A362D-7D71-69BF-0521-8A1C2628FEA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42699" y="247125"/>
            <a:ext cx="4123268" cy="2061635"/>
          </a:xfrm>
          <a:prstGeom prst="rect">
            <a:avLst/>
          </a:prstGeom>
        </p:spPr>
      </p:pic>
      <p:pic>
        <p:nvPicPr>
          <p:cNvPr id="2" name="Picture 1">
            <a:extLst>
              <a:ext uri="{FF2B5EF4-FFF2-40B4-BE49-F238E27FC236}">
                <a16:creationId xmlns:a16="http://schemas.microsoft.com/office/drawing/2014/main" id="{A1FC0036-C99B-56D8-5DC8-98E197CF918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37401" y="3522665"/>
            <a:ext cx="5915212" cy="2070324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A719A541-61E6-4AF1-DAA6-6A3ECA5B1BFE}"/>
              </a:ext>
            </a:extLst>
          </p:cNvPr>
          <p:cNvSpPr txBox="1"/>
          <p:nvPr/>
        </p:nvSpPr>
        <p:spPr>
          <a:xfrm>
            <a:off x="437402" y="5592989"/>
            <a:ext cx="5915211" cy="43505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15000"/>
              </a:lnSpc>
              <a:spcBef>
                <a:spcPts val="400"/>
              </a:spcBef>
              <a:spcAft>
                <a:spcPts val="400"/>
              </a:spcAft>
            </a:pPr>
            <a:r>
              <a:rPr lang="en-GB" sz="10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5</a:t>
            </a:r>
            <a:r>
              <a:rPr lang="en-GB" sz="1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: </a:t>
            </a:r>
            <a:r>
              <a:rPr lang="en-GB" sz="1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bsolute numbers of B cell subsets after stimulation </a:t>
            </a:r>
            <a:r>
              <a:rPr lang="en-GB" sz="1000" i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in vitro</a:t>
            </a:r>
            <a:r>
              <a:rPr lang="en-GB" sz="1000" i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10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in different cohorts. </a:t>
            </a:r>
            <a:r>
              <a:rPr lang="en-GB" sz="1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 = </a:t>
            </a:r>
            <a:r>
              <a:rPr lang="en-GB" sz="10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Wilcoxon rank-sum tests with </a:t>
            </a:r>
            <a:r>
              <a:rPr lang="en-GB" sz="1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Holm’s correction</a:t>
            </a:r>
            <a:r>
              <a:rPr lang="en-GB" sz="1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</a:t>
            </a:r>
            <a:endParaRPr lang="en-CH" sz="1000" dirty="0">
              <a:effectLst/>
              <a:latin typeface="centur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3444635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5D5A9F03-A0EC-A883-B372-1FF6D45C3874}"/>
              </a:ext>
            </a:extLst>
          </p:cNvPr>
          <p:cNvSpPr txBox="1"/>
          <p:nvPr/>
        </p:nvSpPr>
        <p:spPr>
          <a:xfrm>
            <a:off x="384328" y="5754386"/>
            <a:ext cx="6002278" cy="788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15000"/>
              </a:lnSpc>
              <a:spcBef>
                <a:spcPts val="400"/>
              </a:spcBef>
              <a:spcAft>
                <a:spcPts val="400"/>
              </a:spcAft>
            </a:pPr>
            <a:r>
              <a:rPr lang="en-GB" sz="10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7</a:t>
            </a:r>
            <a:r>
              <a:rPr lang="en-GB" sz="1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: Serum </a:t>
            </a:r>
            <a:r>
              <a:rPr lang="en-US" sz="1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nti-EBNA1 IgG normalized to total IgG in patients with EBV reactivation (EBV+, n = 8) and without EBV reactivation (EBV-, n = 7) after </a:t>
            </a:r>
            <a:r>
              <a:rPr lang="en-US" sz="10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HSCT</a:t>
            </a:r>
            <a:r>
              <a:rPr lang="en-US" sz="1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(</a:t>
            </a:r>
            <a:r>
              <a:rPr lang="en-US" sz="1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 = Wilcoxon rank-sum tests with </a:t>
            </a:r>
            <a:r>
              <a:rPr lang="en-GB" sz="1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Holm’s correction</a:t>
            </a:r>
            <a:r>
              <a:rPr lang="en-US" sz="1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. Pre = 1 month before </a:t>
            </a:r>
            <a:r>
              <a:rPr lang="en-US" sz="10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HSCT</a:t>
            </a:r>
            <a:r>
              <a:rPr lang="en-US" sz="1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M1 = 1 month after </a:t>
            </a:r>
            <a:r>
              <a:rPr lang="en-US" sz="10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HSCT</a:t>
            </a:r>
            <a:r>
              <a:rPr lang="en-US" sz="1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M12/12 = 12 resp. 24 months after </a:t>
            </a:r>
            <a:r>
              <a:rPr lang="en-US" sz="10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HSCT</a:t>
            </a:r>
            <a:r>
              <a:rPr lang="en-US" sz="1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</a:t>
            </a:r>
            <a:endParaRPr lang="en-CH" sz="1000" dirty="0">
              <a:effectLst/>
              <a:latin typeface="centur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BE57440D-16BB-28D2-4CDD-699861D3A90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576244" y="3160527"/>
            <a:ext cx="3705513" cy="2593859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E67032F1-DF72-B058-5B6B-EEAADCCD50AB}"/>
              </a:ext>
            </a:extLst>
          </p:cNvPr>
          <p:cNvSpPr txBox="1"/>
          <p:nvPr/>
        </p:nvSpPr>
        <p:spPr>
          <a:xfrm>
            <a:off x="384327" y="2179140"/>
            <a:ext cx="6124595" cy="61202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15000"/>
              </a:lnSpc>
              <a:spcBef>
                <a:spcPts val="400"/>
              </a:spcBef>
              <a:spcAft>
                <a:spcPts val="400"/>
              </a:spcAft>
            </a:pPr>
            <a:r>
              <a:rPr lang="en-GB" sz="10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6</a:t>
            </a:r>
            <a:r>
              <a:rPr lang="en-GB" sz="1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: Normalized </a:t>
            </a:r>
            <a:r>
              <a:rPr lang="en-US" sz="1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ntigen-specific IgG levels in cell culture supernatants after stimulation </a:t>
            </a:r>
            <a:r>
              <a:rPr lang="en-US" sz="1000" i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in vitro</a:t>
            </a:r>
            <a:r>
              <a:rPr lang="en-US" sz="1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 </a:t>
            </a:r>
            <a:r>
              <a:rPr lang="en-US" sz="10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Individually measured IgG levels against foreign antigens (A-C) and autoantigens (D-F) were normalized to total IgG measured in the same supernatants.</a:t>
            </a:r>
            <a:r>
              <a:rPr lang="en-US" sz="1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 = Wilcoxon rank-sum tests with </a:t>
            </a:r>
            <a:r>
              <a:rPr lang="en-GB" sz="1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Holm’s correction.</a:t>
            </a:r>
            <a:endParaRPr lang="en-CH" sz="1000" dirty="0">
              <a:effectLst/>
              <a:latin typeface="centur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cxnSp>
        <p:nvCxnSpPr>
          <p:cNvPr id="6" name="Straight Connector 5">
            <a:extLst>
              <a:ext uri="{FF2B5EF4-FFF2-40B4-BE49-F238E27FC236}">
                <a16:creationId xmlns:a16="http://schemas.microsoft.com/office/drawing/2014/main" id="{164B98E2-74C4-E4F8-B8EE-ABB2CE20CFDD}"/>
              </a:ext>
            </a:extLst>
          </p:cNvPr>
          <p:cNvCxnSpPr>
            <a:cxnSpLocks/>
          </p:cNvCxnSpPr>
          <p:nvPr/>
        </p:nvCxnSpPr>
        <p:spPr>
          <a:xfrm>
            <a:off x="384327" y="601141"/>
            <a:ext cx="3018578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" name="Straight Connector 6">
            <a:extLst>
              <a:ext uri="{FF2B5EF4-FFF2-40B4-BE49-F238E27FC236}">
                <a16:creationId xmlns:a16="http://schemas.microsoft.com/office/drawing/2014/main" id="{B8F7777D-CDCA-66E5-003D-E97BDFF26A96}"/>
              </a:ext>
            </a:extLst>
          </p:cNvPr>
          <p:cNvCxnSpPr>
            <a:cxnSpLocks/>
          </p:cNvCxnSpPr>
          <p:nvPr/>
        </p:nvCxnSpPr>
        <p:spPr>
          <a:xfrm>
            <a:off x="3512054" y="601141"/>
            <a:ext cx="2988036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" name="TextBox 7">
            <a:extLst>
              <a:ext uri="{FF2B5EF4-FFF2-40B4-BE49-F238E27FC236}">
                <a16:creationId xmlns:a16="http://schemas.microsoft.com/office/drawing/2014/main" id="{FB93630B-3DBA-2D00-1B3D-078FF1D5480B}"/>
              </a:ext>
            </a:extLst>
          </p:cNvPr>
          <p:cNvSpPr txBox="1"/>
          <p:nvPr/>
        </p:nvSpPr>
        <p:spPr>
          <a:xfrm>
            <a:off x="1395635" y="410634"/>
            <a:ext cx="95410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H" sz="800">
                <a:latin typeface="Arial" panose="020B0604020202020204" pitchFamily="34" charset="0"/>
                <a:cs typeface="Arial" panose="020B0604020202020204" pitchFamily="34" charset="0"/>
              </a:rPr>
              <a:t>Foreign antigens</a:t>
            </a:r>
            <a:endParaRPr lang="en-CH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38EBAB9A-F35D-3F9D-15C9-234F73A6853B}"/>
              </a:ext>
            </a:extLst>
          </p:cNvPr>
          <p:cNvSpPr txBox="1"/>
          <p:nvPr/>
        </p:nvSpPr>
        <p:spPr>
          <a:xfrm>
            <a:off x="4597824" y="410634"/>
            <a:ext cx="78899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H" sz="800" dirty="0">
                <a:latin typeface="Arial" panose="020B0604020202020204" pitchFamily="34" charset="0"/>
                <a:cs typeface="Arial" panose="020B0604020202020204" pitchFamily="34" charset="0"/>
              </a:rPr>
              <a:t>Autoantigens</a:t>
            </a:r>
          </a:p>
        </p:txBody>
      </p:sp>
      <p:pic>
        <p:nvPicPr>
          <p:cNvPr id="10" name="Picture 9">
            <a:extLst>
              <a:ext uri="{FF2B5EF4-FFF2-40B4-BE49-F238E27FC236}">
                <a16:creationId xmlns:a16="http://schemas.microsoft.com/office/drawing/2014/main" id="{9F2FF4E8-B0AD-F9B6-E558-DE8A95BC09A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84327" y="630963"/>
            <a:ext cx="6124595" cy="141336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43869911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5FF9DA84799B1647BDBC1150533BF2A2" ma:contentTypeVersion="15" ma:contentTypeDescription="Create a new document." ma:contentTypeScope="" ma:versionID="5c6988df5ecc2e07b99a901be0718aa4">
  <xsd:schema xmlns:xsd="http://www.w3.org/2001/XMLSchema" xmlns:xs="http://www.w3.org/2001/XMLSchema" xmlns:p="http://schemas.microsoft.com/office/2006/metadata/properties" xmlns:ns2="ed72edfa-3e5f-4feb-8282-c15e67952919" xmlns:ns3="4e0eccb1-5cc0-45f3-9a28-48024967b273" targetNamespace="http://schemas.microsoft.com/office/2006/metadata/properties" ma:root="true" ma:fieldsID="0522ece6bc902d0b33b568df23f7bb91" ns2:_="" ns3:_="">
    <xsd:import namespace="ed72edfa-3e5f-4feb-8282-c15e67952919"/>
    <xsd:import namespace="4e0eccb1-5cc0-45f3-9a28-48024967b273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2:MediaServiceDateTaken" minOccurs="0"/>
                <xsd:element ref="ns2:lcf76f155ced4ddcb4097134ff3c332f" minOccurs="0"/>
                <xsd:element ref="ns3:TaxCatchAll" minOccurs="0"/>
                <xsd:element ref="ns2:MediaServiceOCR" minOccurs="0"/>
                <xsd:element ref="ns2:MediaServiceGenerationTime" minOccurs="0"/>
                <xsd:element ref="ns2:MediaServiceEventHashCode" minOccurs="0"/>
                <xsd:element ref="ns3:SharedWithUsers" minOccurs="0"/>
                <xsd:element ref="ns3:SharedWithDetails" minOccurs="0"/>
                <xsd:element ref="ns2:MediaServiceObjectDetectorVersions" minOccurs="0"/>
                <xsd:element ref="ns2:MediaServiceLocation" minOccurs="0"/>
                <xsd:element ref="ns2:MediaLengthInSeconds" minOccurs="0"/>
                <xsd:element ref="ns2:MediaServiceSearchPropertie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ed72edfa-3e5f-4feb-8282-c15e67952919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DateTaken" ma:index="10" nillable="true" ma:displayName="MediaServiceDateTaken" ma:hidden="true" ma:indexed="true" ma:internalName="MediaServiceDateTaken" ma:readOnly="true">
      <xsd:simpleType>
        <xsd:restriction base="dms:Text"/>
      </xsd:simpleType>
    </xsd:element>
    <xsd:element name="lcf76f155ced4ddcb4097134ff3c332f" ma:index="12" nillable="true" ma:taxonomy="true" ma:internalName="lcf76f155ced4ddcb4097134ff3c332f" ma:taxonomyFieldName="MediaServiceImageTags" ma:displayName="Image Tags" ma:readOnly="false" ma:fieldId="{5cf76f15-5ced-4ddc-b409-7134ff3c332f}" ma:taxonomyMulti="true" ma:sspId="9c83734c-e80f-495c-8e9e-a06dbba8e803" ma:termSetId="09814cd3-568e-fe90-9814-8d621ff8fb84" ma:anchorId="fba54fb3-c3e1-fe81-a776-ca4b69148c4d" ma:open="true" ma:isKeyword="false">
      <xsd:complexType>
        <xsd:sequence>
          <xsd:element ref="pc:Terms" minOccurs="0" maxOccurs="1"/>
        </xsd:sequence>
      </xsd:complexType>
    </xsd:element>
    <xsd:element name="MediaServiceOCR" ma:index="14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5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6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ObjectDetectorVersions" ma:index="19" nillable="true" ma:displayName="MediaServiceObjectDetectorVersions" ma:description="" ma:hidden="true" ma:indexed="true" ma:internalName="MediaServiceObjectDetectorVersions" ma:readOnly="true">
      <xsd:simpleType>
        <xsd:restriction base="dms:Text"/>
      </xsd:simpleType>
    </xsd:element>
    <xsd:element name="MediaServiceLocation" ma:index="20" nillable="true" ma:displayName="Location" ma:description="" ma:indexed="true" ma:internalName="MediaServiceLocation" ma:readOnly="true">
      <xsd:simpleType>
        <xsd:restriction base="dms:Text"/>
      </xsd:simpleType>
    </xsd:element>
    <xsd:element name="MediaLengthInSeconds" ma:index="21" nillable="true" ma:displayName="MediaLengthInSeconds" ma:hidden="true" ma:internalName="MediaLengthInSeconds" ma:readOnly="true">
      <xsd:simpleType>
        <xsd:restriction base="dms:Unknown"/>
      </xsd:simpleType>
    </xsd:element>
    <xsd:element name="MediaServiceSearchProperties" ma:index="22" nillable="true" ma:displayName="MediaServiceSearchProperties" ma:hidden="true" ma:internalName="MediaServiceSearchProperties" ma:readOnly="true">
      <xsd:simpleType>
        <xsd:restriction base="dms:Note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4e0eccb1-5cc0-45f3-9a28-48024967b273" elementFormDefault="qualified">
    <xsd:import namespace="http://schemas.microsoft.com/office/2006/documentManagement/types"/>
    <xsd:import namespace="http://schemas.microsoft.com/office/infopath/2007/PartnerControls"/>
    <xsd:element name="TaxCatchAll" ma:index="13" nillable="true" ma:displayName="Taxonomy Catch All Column" ma:hidden="true" ma:list="{7e86367e-f166-4e94-8046-1d2e925449f9}" ma:internalName="TaxCatchAll" ma:showField="CatchAllData" ma:web="4e0eccb1-5cc0-45f3-9a28-48024967b273">
      <xsd:complexType>
        <xsd:complexContent>
          <xsd:extension base="dms:MultiChoiceLookup">
            <xsd:sequence>
              <xsd:element name="Value" type="dms:Lookup" maxOccurs="unbounded" minOccurs="0" nillable="true"/>
            </xsd:sequence>
          </xsd:extension>
        </xsd:complexContent>
      </xsd:complexType>
    </xsd:element>
    <xsd:element name="SharedWithUsers" ma:index="17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8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Props1.xml><?xml version="1.0" encoding="utf-8"?>
<ds:datastoreItem xmlns:ds="http://schemas.openxmlformats.org/officeDocument/2006/customXml" ds:itemID="{05414ABD-13EF-47D0-98FB-D04B379E8C20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ed72edfa-3e5f-4feb-8282-c15e67952919"/>
    <ds:schemaRef ds:uri="4e0eccb1-5cc0-45f3-9a28-48024967b273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2.xml><?xml version="1.0" encoding="utf-8"?>
<ds:datastoreItem xmlns:ds="http://schemas.openxmlformats.org/officeDocument/2006/customXml" ds:itemID="{D3D839F8-539E-42E1-B6A4-0D40C300E420}">
  <ds:schemaRefs>
    <ds:schemaRef ds:uri="http://schemas.microsoft.com/sharepoint/v3/contenttype/forms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23785</TotalTime>
  <Words>1410</Words>
  <Application>Microsoft Macintosh PowerPoint</Application>
  <PresentationFormat>A4 Paper (210x297 mm)</PresentationFormat>
  <Paragraphs>640</Paragraphs>
  <Slides>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11" baseType="lpstr">
      <vt:lpstr>Arial</vt:lpstr>
      <vt:lpstr>Calibri</vt:lpstr>
      <vt:lpstr>Calibri Light</vt:lpstr>
      <vt:lpstr>centur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Zoe Marti</dc:creator>
  <cp:lastModifiedBy>Zoe Marti</cp:lastModifiedBy>
  <cp:revision>10</cp:revision>
  <cp:lastPrinted>2023-10-08T19:43:55Z</cp:lastPrinted>
  <dcterms:created xsi:type="dcterms:W3CDTF">2023-09-28T11:23:15Z</dcterms:created>
  <dcterms:modified xsi:type="dcterms:W3CDTF">2024-03-06T06:08:26Z</dcterms:modified>
</cp:coreProperties>
</file>